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8" r:id="rId2"/>
    <p:sldId id="267" r:id="rId3"/>
    <p:sldId id="269" r:id="rId4"/>
    <p:sldId id="272" r:id="rId5"/>
    <p:sldId id="262" r:id="rId6"/>
  </p:sldIdLst>
  <p:sldSz cx="8999538" cy="11879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1" id="{B473502C-7E89-B446-BA7A-D1C768EDC723}">
          <p14:sldIdLst/>
        </p14:section>
        <p14:section name="2" id="{766494C2-6C22-5A4D-ADEA-8F0F65153194}">
          <p14:sldIdLst>
            <p14:sldId id="268"/>
            <p14:sldId id="267"/>
            <p14:sldId id="269"/>
            <p14:sldId id="272"/>
            <p14:sldId id="26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73F9"/>
    <a:srgbClr val="65FCC1"/>
    <a:srgbClr val="32E3D9"/>
    <a:srgbClr val="00B4EC"/>
    <a:srgbClr val="6724FE"/>
    <a:srgbClr val="FF2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52B344-ABA0-1C4D-9F52-70A0A03FA91F}" v="3" dt="2026-02-07T00:26:22.44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6503"/>
    <p:restoredTop sz="94637"/>
  </p:normalViewPr>
  <p:slideViewPr>
    <p:cSldViewPr snapToGrid="0">
      <p:cViewPr>
        <p:scale>
          <a:sx n="81" d="100"/>
          <a:sy n="81" d="100"/>
        </p:scale>
        <p:origin x="1128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loé Landry" userId="111132de-c275-47fc-8985-bc045a9ff9c7" providerId="ADAL" clId="{4A85BDF2-5504-034D-85E8-EF39C722D286}"/>
    <pc:docChg chg="undo custSel addSld modSld">
      <pc:chgData name="Chloé Landry" userId="111132de-c275-47fc-8985-bc045a9ff9c7" providerId="ADAL" clId="{4A85BDF2-5504-034D-85E8-EF39C722D286}" dt="2026-01-28T00:01:02.561" v="1204" actId="1036"/>
      <pc:docMkLst>
        <pc:docMk/>
      </pc:docMkLst>
      <pc:sldChg chg="addSp delSp modSp mod">
        <pc:chgData name="Chloé Landry" userId="111132de-c275-47fc-8985-bc045a9ff9c7" providerId="ADAL" clId="{4A85BDF2-5504-034D-85E8-EF39C722D286}" dt="2026-01-27T23:50:21.454" v="1103" actId="1076"/>
        <pc:sldMkLst>
          <pc:docMk/>
          <pc:sldMk cId="2351317433" sldId="261"/>
        </pc:sldMkLst>
      </pc:sldChg>
      <pc:sldChg chg="addSp delSp modSp mod">
        <pc:chgData name="Chloé Landry" userId="111132de-c275-47fc-8985-bc045a9ff9c7" providerId="ADAL" clId="{4A85BDF2-5504-034D-85E8-EF39C722D286}" dt="2025-08-11T05:15:31.302" v="263" actId="20577"/>
        <pc:sldMkLst>
          <pc:docMk/>
          <pc:sldMk cId="1463528531" sldId="263"/>
        </pc:sldMkLst>
      </pc:sldChg>
      <pc:sldChg chg="addSp delSp modSp mod">
        <pc:chgData name="Chloé Landry" userId="111132de-c275-47fc-8985-bc045a9ff9c7" providerId="ADAL" clId="{4A85BDF2-5504-034D-85E8-EF39C722D286}" dt="2026-01-28T00:01:02.561" v="1204" actId="1036"/>
        <pc:sldMkLst>
          <pc:docMk/>
          <pc:sldMk cId="1247179969" sldId="267"/>
        </pc:sldMkLst>
        <pc:spChg chg="mod">
          <ac:chgData name="Chloé Landry" userId="111132de-c275-47fc-8985-bc045a9ff9c7" providerId="ADAL" clId="{4A85BDF2-5504-034D-85E8-EF39C722D286}" dt="2026-01-28T00:00:53.325" v="1200" actId="1076"/>
          <ac:spMkLst>
            <pc:docMk/>
            <pc:sldMk cId="1247179969" sldId="267"/>
            <ac:spMk id="3" creationId="{25A74E1D-2C2B-1A56-9968-0F2636681345}"/>
          </ac:spMkLst>
        </pc:spChg>
        <pc:picChg chg="add mod">
          <ac:chgData name="Chloé Landry" userId="111132de-c275-47fc-8985-bc045a9ff9c7" providerId="ADAL" clId="{4A85BDF2-5504-034D-85E8-EF39C722D286}" dt="2026-01-27T23:59:59.785" v="1184" actId="1038"/>
          <ac:picMkLst>
            <pc:docMk/>
            <pc:sldMk cId="1247179969" sldId="267"/>
            <ac:picMk id="4" creationId="{FA649EC4-127C-4C41-5406-C04374697EF0}"/>
          </ac:picMkLst>
        </pc:picChg>
        <pc:picChg chg="add mod">
          <ac:chgData name="Chloé Landry" userId="111132de-c275-47fc-8985-bc045a9ff9c7" providerId="ADAL" clId="{4A85BDF2-5504-034D-85E8-EF39C722D286}" dt="2026-01-27T23:59:59.785" v="1184" actId="1038"/>
          <ac:picMkLst>
            <pc:docMk/>
            <pc:sldMk cId="1247179969" sldId="267"/>
            <ac:picMk id="8" creationId="{C21E65B7-1B61-0163-9926-8791F223EC91}"/>
          </ac:picMkLst>
        </pc:picChg>
        <pc:picChg chg="add mod">
          <ac:chgData name="Chloé Landry" userId="111132de-c275-47fc-8985-bc045a9ff9c7" providerId="ADAL" clId="{4A85BDF2-5504-034D-85E8-EF39C722D286}" dt="2026-01-27T23:59:59.785" v="1184" actId="1038"/>
          <ac:picMkLst>
            <pc:docMk/>
            <pc:sldMk cId="1247179969" sldId="267"/>
            <ac:picMk id="12" creationId="{8C97CBF5-C535-1038-E33C-6C32F9C1C72C}"/>
          </ac:picMkLst>
        </pc:picChg>
        <pc:picChg chg="add mod">
          <ac:chgData name="Chloé Landry" userId="111132de-c275-47fc-8985-bc045a9ff9c7" providerId="ADAL" clId="{4A85BDF2-5504-034D-85E8-EF39C722D286}" dt="2026-01-28T00:00:57.548" v="1202" actId="1036"/>
          <ac:picMkLst>
            <pc:docMk/>
            <pc:sldMk cId="1247179969" sldId="267"/>
            <ac:picMk id="16" creationId="{F964B283-1F08-4353-3B84-FD197CDE3AB0}"/>
          </ac:picMkLst>
        </pc:picChg>
        <pc:picChg chg="add mod">
          <ac:chgData name="Chloé Landry" userId="111132de-c275-47fc-8985-bc045a9ff9c7" providerId="ADAL" clId="{4A85BDF2-5504-034D-85E8-EF39C722D286}" dt="2026-01-28T00:00:57.548" v="1202" actId="1036"/>
          <ac:picMkLst>
            <pc:docMk/>
            <pc:sldMk cId="1247179969" sldId="267"/>
            <ac:picMk id="20" creationId="{D3113480-826A-6B37-A3D5-D4BADAC9C58F}"/>
          </ac:picMkLst>
        </pc:picChg>
        <pc:picChg chg="add mod">
          <ac:chgData name="Chloé Landry" userId="111132de-c275-47fc-8985-bc045a9ff9c7" providerId="ADAL" clId="{4A85BDF2-5504-034D-85E8-EF39C722D286}" dt="2026-01-28T00:01:02.561" v="1204" actId="1036"/>
          <ac:picMkLst>
            <pc:docMk/>
            <pc:sldMk cId="1247179969" sldId="267"/>
            <ac:picMk id="24" creationId="{E6FB2353-80A2-7FF1-7438-D5F9ACD483DC}"/>
          </ac:picMkLst>
        </pc:picChg>
        <pc:picChg chg="add mod">
          <ac:chgData name="Chloé Landry" userId="111132de-c275-47fc-8985-bc045a9ff9c7" providerId="ADAL" clId="{4A85BDF2-5504-034D-85E8-EF39C722D286}" dt="2026-01-28T00:00:57.548" v="1202" actId="1036"/>
          <ac:picMkLst>
            <pc:docMk/>
            <pc:sldMk cId="1247179969" sldId="267"/>
            <ac:picMk id="26" creationId="{EFA59DBC-B841-D319-0A9A-F6F96386BA01}"/>
          </ac:picMkLst>
        </pc:picChg>
        <pc:picChg chg="add mod">
          <ac:chgData name="Chloé Landry" userId="111132de-c275-47fc-8985-bc045a9ff9c7" providerId="ADAL" clId="{4A85BDF2-5504-034D-85E8-EF39C722D286}" dt="2026-01-28T00:01:02.561" v="1204" actId="1036"/>
          <ac:picMkLst>
            <pc:docMk/>
            <pc:sldMk cId="1247179969" sldId="267"/>
            <ac:picMk id="28" creationId="{70F62057-0767-9ECE-57C6-DDD216C25ED5}"/>
          </ac:picMkLst>
        </pc:picChg>
        <pc:picChg chg="add mod">
          <ac:chgData name="Chloé Landry" userId="111132de-c275-47fc-8985-bc045a9ff9c7" providerId="ADAL" clId="{4A85BDF2-5504-034D-85E8-EF39C722D286}" dt="2026-01-28T00:00:15.171" v="1188" actId="1035"/>
          <ac:picMkLst>
            <pc:docMk/>
            <pc:sldMk cId="1247179969" sldId="267"/>
            <ac:picMk id="30" creationId="{8D55EAAF-D5E5-7EA1-9D7F-1AE878622981}"/>
          </ac:picMkLst>
        </pc:picChg>
        <pc:picChg chg="add mod">
          <ac:chgData name="Chloé Landry" userId="111132de-c275-47fc-8985-bc045a9ff9c7" providerId="ADAL" clId="{4A85BDF2-5504-034D-85E8-EF39C722D286}" dt="2026-01-28T00:00:15.171" v="1188" actId="1035"/>
          <ac:picMkLst>
            <pc:docMk/>
            <pc:sldMk cId="1247179969" sldId="267"/>
            <ac:picMk id="32" creationId="{247DD772-9CF3-F034-673B-D1FD0E7D1540}"/>
          </ac:picMkLst>
        </pc:picChg>
      </pc:sldChg>
      <pc:sldChg chg="addSp delSp modSp mod modNotesTx">
        <pc:chgData name="Chloé Landry" userId="111132de-c275-47fc-8985-bc045a9ff9c7" providerId="ADAL" clId="{4A85BDF2-5504-034D-85E8-EF39C722D286}" dt="2025-08-11T05:29:05.753" v="510" actId="1035"/>
        <pc:sldMkLst>
          <pc:docMk/>
          <pc:sldMk cId="3298780960" sldId="269"/>
        </pc:sldMkLst>
      </pc:sldChg>
      <pc:sldChg chg="addSp delSp modSp new mod">
        <pc:chgData name="Chloé Landry" userId="111132de-c275-47fc-8985-bc045a9ff9c7" providerId="ADAL" clId="{4A85BDF2-5504-034D-85E8-EF39C722D286}" dt="2025-08-11T05:52:37.991" v="922" actId="1076"/>
        <pc:sldMkLst>
          <pc:docMk/>
          <pc:sldMk cId="3415687839" sldId="270"/>
        </pc:sldMkLst>
      </pc:sldChg>
    </pc:docChg>
  </pc:docChgLst>
  <pc:docChgLst>
    <pc:chgData name="Chloé Landry" userId="111132de-c275-47fc-8985-bc045a9ff9c7" providerId="ADAL" clId="{44F20E46-9B0C-C446-9D1D-4471EE34A8CA}"/>
    <pc:docChg chg="undo custSel addSld modSld">
      <pc:chgData name="Chloé Landry" userId="111132de-c275-47fc-8985-bc045a9ff9c7" providerId="ADAL" clId="{44F20E46-9B0C-C446-9D1D-4471EE34A8CA}" dt="2025-08-15T04:58:08.526" v="5271" actId="20577"/>
      <pc:docMkLst>
        <pc:docMk/>
      </pc:docMkLst>
      <pc:sldChg chg="modSp mod">
        <pc:chgData name="Chloé Landry" userId="111132de-c275-47fc-8985-bc045a9ff9c7" providerId="ADAL" clId="{44F20E46-9B0C-C446-9D1D-4471EE34A8CA}" dt="2025-08-12T01:54:14.366" v="2922" actId="20577"/>
        <pc:sldMkLst>
          <pc:docMk/>
          <pc:sldMk cId="3154595557" sldId="256"/>
        </pc:sldMkLst>
      </pc:sldChg>
      <pc:sldChg chg="modSp mod">
        <pc:chgData name="Chloé Landry" userId="111132de-c275-47fc-8985-bc045a9ff9c7" providerId="ADAL" clId="{44F20E46-9B0C-C446-9D1D-4471EE34A8CA}" dt="2025-08-12T02:05:19.259" v="3036" actId="20577"/>
        <pc:sldMkLst>
          <pc:docMk/>
          <pc:sldMk cId="820707913" sldId="257"/>
        </pc:sldMkLst>
      </pc:sldChg>
      <pc:sldChg chg="addSp delSp modSp mod">
        <pc:chgData name="Chloé Landry" userId="111132de-c275-47fc-8985-bc045a9ff9c7" providerId="ADAL" clId="{44F20E46-9B0C-C446-9D1D-4471EE34A8CA}" dt="2025-08-15T04:58:08.526" v="5271" actId="20577"/>
        <pc:sldMkLst>
          <pc:docMk/>
          <pc:sldMk cId="2595074155" sldId="258"/>
        </pc:sldMkLst>
      </pc:sldChg>
      <pc:sldChg chg="modSp mod">
        <pc:chgData name="Chloé Landry" userId="111132de-c275-47fc-8985-bc045a9ff9c7" providerId="ADAL" clId="{44F20E46-9B0C-C446-9D1D-4471EE34A8CA}" dt="2025-08-15T04:26:19" v="4912" actId="20577"/>
        <pc:sldMkLst>
          <pc:docMk/>
          <pc:sldMk cId="2664825074" sldId="259"/>
        </pc:sldMkLst>
      </pc:sldChg>
      <pc:sldChg chg="modSp mod">
        <pc:chgData name="Chloé Landry" userId="111132de-c275-47fc-8985-bc045a9ff9c7" providerId="ADAL" clId="{44F20E46-9B0C-C446-9D1D-4471EE34A8CA}" dt="2025-08-15T04:26:23.527" v="4914" actId="20577"/>
        <pc:sldMkLst>
          <pc:docMk/>
          <pc:sldMk cId="443727691" sldId="260"/>
        </pc:sldMkLst>
      </pc:sldChg>
      <pc:sldChg chg="addSp modSp mod">
        <pc:chgData name="Chloé Landry" userId="111132de-c275-47fc-8985-bc045a9ff9c7" providerId="ADAL" clId="{44F20E46-9B0C-C446-9D1D-4471EE34A8CA}" dt="2025-08-12T02:45:20.663" v="3208" actId="20577"/>
        <pc:sldMkLst>
          <pc:docMk/>
          <pc:sldMk cId="2351317433" sldId="261"/>
        </pc:sldMkLst>
      </pc:sldChg>
      <pc:sldChg chg="modSp mod">
        <pc:chgData name="Chloé Landry" userId="111132de-c275-47fc-8985-bc045a9ff9c7" providerId="ADAL" clId="{44F20E46-9B0C-C446-9D1D-4471EE34A8CA}" dt="2025-08-15T04:32:42.907" v="5170" actId="20577"/>
        <pc:sldMkLst>
          <pc:docMk/>
          <pc:sldMk cId="877368732" sldId="262"/>
        </pc:sldMkLst>
      </pc:sldChg>
      <pc:sldChg chg="addSp modSp mod">
        <pc:chgData name="Chloé Landry" userId="111132de-c275-47fc-8985-bc045a9ff9c7" providerId="ADAL" clId="{44F20E46-9B0C-C446-9D1D-4471EE34A8CA}" dt="2025-08-12T01:49:19.347" v="2673" actId="20577"/>
        <pc:sldMkLst>
          <pc:docMk/>
          <pc:sldMk cId="1463528531" sldId="263"/>
        </pc:sldMkLst>
      </pc:sldChg>
      <pc:sldChg chg="modSp mod">
        <pc:chgData name="Chloé Landry" userId="111132de-c275-47fc-8985-bc045a9ff9c7" providerId="ADAL" clId="{44F20E46-9B0C-C446-9D1D-4471EE34A8CA}" dt="2025-08-12T03:03:32.691" v="3573" actId="255"/>
        <pc:sldMkLst>
          <pc:docMk/>
          <pc:sldMk cId="2833800643" sldId="264"/>
        </pc:sldMkLst>
      </pc:sldChg>
      <pc:sldChg chg="modSp mod">
        <pc:chgData name="Chloé Landry" userId="111132de-c275-47fc-8985-bc045a9ff9c7" providerId="ADAL" clId="{44F20E46-9B0C-C446-9D1D-4471EE34A8CA}" dt="2025-08-12T01:57:06.690" v="2962" actId="1076"/>
        <pc:sldMkLst>
          <pc:docMk/>
          <pc:sldMk cId="907146193" sldId="265"/>
        </pc:sldMkLst>
      </pc:sldChg>
      <pc:sldChg chg="addSp delSp modSp mod modNotesTx">
        <pc:chgData name="Chloé Landry" userId="111132de-c275-47fc-8985-bc045a9ff9c7" providerId="ADAL" clId="{44F20E46-9B0C-C446-9D1D-4471EE34A8CA}" dt="2025-08-12T03:03:45.035" v="3574" actId="255"/>
        <pc:sldMkLst>
          <pc:docMk/>
          <pc:sldMk cId="2888321743" sldId="266"/>
        </pc:sldMkLst>
      </pc:sldChg>
      <pc:sldChg chg="addSp delSp modSp mod">
        <pc:chgData name="Chloé Landry" userId="111132de-c275-47fc-8985-bc045a9ff9c7" providerId="ADAL" clId="{44F20E46-9B0C-C446-9D1D-4471EE34A8CA}" dt="2025-08-15T04:26:38.674" v="4919" actId="20577"/>
        <pc:sldMkLst>
          <pc:docMk/>
          <pc:sldMk cId="1247179969" sldId="267"/>
        </pc:sldMkLst>
      </pc:sldChg>
      <pc:sldChg chg="addSp delSp modSp mod">
        <pc:chgData name="Chloé Landry" userId="111132de-c275-47fc-8985-bc045a9ff9c7" providerId="ADAL" clId="{44F20E46-9B0C-C446-9D1D-4471EE34A8CA}" dt="2025-08-15T04:26:33.973" v="4917" actId="20577"/>
        <pc:sldMkLst>
          <pc:docMk/>
          <pc:sldMk cId="4262463860" sldId="268"/>
        </pc:sldMkLst>
      </pc:sldChg>
      <pc:sldChg chg="addSp delSp modSp mod">
        <pc:chgData name="Chloé Landry" userId="111132de-c275-47fc-8985-bc045a9ff9c7" providerId="ADAL" clId="{44F20E46-9B0C-C446-9D1D-4471EE34A8CA}" dt="2025-08-15T04:39:16.001" v="5212" actId="164"/>
        <pc:sldMkLst>
          <pc:docMk/>
          <pc:sldMk cId="3298780960" sldId="269"/>
        </pc:sldMkLst>
      </pc:sldChg>
      <pc:sldChg chg="addSp delSp modSp mod">
        <pc:chgData name="Chloé Landry" userId="111132de-c275-47fc-8985-bc045a9ff9c7" providerId="ADAL" clId="{44F20E46-9B0C-C446-9D1D-4471EE34A8CA}" dt="2025-08-15T04:26:28.073" v="4915" actId="20577"/>
        <pc:sldMkLst>
          <pc:docMk/>
          <pc:sldMk cId="3415687839" sldId="270"/>
        </pc:sldMkLst>
      </pc:sldChg>
      <pc:sldChg chg="addSp delSp modSp new mod">
        <pc:chgData name="Chloé Landry" userId="111132de-c275-47fc-8985-bc045a9ff9c7" providerId="ADAL" clId="{44F20E46-9B0C-C446-9D1D-4471EE34A8CA}" dt="2025-08-15T04:32:30.985" v="5168" actId="20577"/>
        <pc:sldMkLst>
          <pc:docMk/>
          <pc:sldMk cId="4274202175" sldId="271"/>
        </pc:sldMkLst>
      </pc:sldChg>
      <pc:sldChg chg="addSp delSp modSp new mod">
        <pc:chgData name="Chloé Landry" userId="111132de-c275-47fc-8985-bc045a9ff9c7" providerId="ADAL" clId="{44F20E46-9B0C-C446-9D1D-4471EE34A8CA}" dt="2025-08-15T04:32:12.642" v="5165" actId="20577"/>
        <pc:sldMkLst>
          <pc:docMk/>
          <pc:sldMk cId="489340006" sldId="272"/>
        </pc:sldMkLst>
      </pc:sldChg>
    </pc:docChg>
  </pc:docChgLst>
  <pc:docChgLst>
    <pc:chgData name="Chloé Landry" userId="111132de-c275-47fc-8985-bc045a9ff9c7" providerId="ADAL" clId="{41F531ED-FF4C-51B2-842B-D1A21AF895D4}"/>
    <pc:docChg chg="undo custSel addSld delSld modSld addSection modSection">
      <pc:chgData name="Chloé Landry" userId="111132de-c275-47fc-8985-bc045a9ff9c7" providerId="ADAL" clId="{41F531ED-FF4C-51B2-842B-D1A21AF895D4}" dt="2026-02-07T00:28:37.218" v="953" actId="2696"/>
      <pc:docMkLst>
        <pc:docMk/>
      </pc:docMkLst>
      <pc:sldChg chg="modSp del mod">
        <pc:chgData name="Chloé Landry" userId="111132de-c275-47fc-8985-bc045a9ff9c7" providerId="ADAL" clId="{41F531ED-FF4C-51B2-842B-D1A21AF895D4}" dt="2026-02-07T00:24:55.403" v="951" actId="2696"/>
        <pc:sldMkLst>
          <pc:docMk/>
          <pc:sldMk cId="3154595557" sldId="256"/>
        </pc:sldMkLst>
        <pc:spChg chg="mod">
          <ac:chgData name="Chloé Landry" userId="111132de-c275-47fc-8985-bc045a9ff9c7" providerId="ADAL" clId="{41F531ED-FF4C-51B2-842B-D1A21AF895D4}" dt="2026-02-07T00:06:38.123" v="912" actId="1076"/>
          <ac:spMkLst>
            <pc:docMk/>
            <pc:sldMk cId="3154595557" sldId="256"/>
            <ac:spMk id="5" creationId="{C4DD13C5-C595-C825-B818-980A1813FD6A}"/>
          </ac:spMkLst>
        </pc:spChg>
      </pc:sldChg>
      <pc:sldChg chg="del">
        <pc:chgData name="Chloé Landry" userId="111132de-c275-47fc-8985-bc045a9ff9c7" providerId="ADAL" clId="{41F531ED-FF4C-51B2-842B-D1A21AF895D4}" dt="2026-02-07T00:24:55.403" v="951" actId="2696"/>
        <pc:sldMkLst>
          <pc:docMk/>
          <pc:sldMk cId="820707913" sldId="257"/>
        </pc:sldMkLst>
      </pc:sldChg>
      <pc:sldChg chg="addSp modSp del mod">
        <pc:chgData name="Chloé Landry" userId="111132de-c275-47fc-8985-bc045a9ff9c7" providerId="ADAL" clId="{41F531ED-FF4C-51B2-842B-D1A21AF895D4}" dt="2026-02-07T00:24:55.403" v="951" actId="2696"/>
        <pc:sldMkLst>
          <pc:docMk/>
          <pc:sldMk cId="2595074155" sldId="258"/>
        </pc:sldMkLst>
        <pc:spChg chg="mod">
          <ac:chgData name="Chloé Landry" userId="111132de-c275-47fc-8985-bc045a9ff9c7" providerId="ADAL" clId="{41F531ED-FF4C-51B2-842B-D1A21AF895D4}" dt="2026-02-06T22:37:19.995" v="897" actId="20577"/>
          <ac:spMkLst>
            <pc:docMk/>
            <pc:sldMk cId="2595074155" sldId="258"/>
            <ac:spMk id="2" creationId="{A061ADC8-438F-6726-7081-F1C887C94C94}"/>
          </ac:spMkLst>
        </pc:spChg>
        <pc:spChg chg="mod">
          <ac:chgData name="Chloé Landry" userId="111132de-c275-47fc-8985-bc045a9ff9c7" providerId="ADAL" clId="{41F531ED-FF4C-51B2-842B-D1A21AF895D4}" dt="2026-02-06T22:37:17.236" v="895" actId="20577"/>
          <ac:spMkLst>
            <pc:docMk/>
            <pc:sldMk cId="2595074155" sldId="258"/>
            <ac:spMk id="19" creationId="{415F595E-60F5-E94D-8EFE-8EF92FD6C8D8}"/>
          </ac:spMkLst>
        </pc:spChg>
        <pc:spChg chg="mod">
          <ac:chgData name="Chloé Landry" userId="111132de-c275-47fc-8985-bc045a9ff9c7" providerId="ADAL" clId="{41F531ED-FF4C-51B2-842B-D1A21AF895D4}" dt="2026-02-06T22:27:12.057" v="839" actId="1076"/>
          <ac:spMkLst>
            <pc:docMk/>
            <pc:sldMk cId="2595074155" sldId="258"/>
            <ac:spMk id="25" creationId="{98A2E4E3-2291-FDC2-A4A9-35BA01BFE3DD}"/>
          </ac:spMkLst>
        </pc:spChg>
        <pc:spChg chg="mod">
          <ac:chgData name="Chloé Landry" userId="111132de-c275-47fc-8985-bc045a9ff9c7" providerId="ADAL" clId="{41F531ED-FF4C-51B2-842B-D1A21AF895D4}" dt="2026-02-06T22:27:12.057" v="839" actId="1076"/>
          <ac:spMkLst>
            <pc:docMk/>
            <pc:sldMk cId="2595074155" sldId="258"/>
            <ac:spMk id="26" creationId="{66BEC18F-A722-EA52-9355-A24743F400E1}"/>
          </ac:spMkLst>
        </pc:spChg>
        <pc:spChg chg="mod">
          <ac:chgData name="Chloé Landry" userId="111132de-c275-47fc-8985-bc045a9ff9c7" providerId="ADAL" clId="{41F531ED-FF4C-51B2-842B-D1A21AF895D4}" dt="2026-02-06T22:27:12.057" v="839" actId="1076"/>
          <ac:spMkLst>
            <pc:docMk/>
            <pc:sldMk cId="2595074155" sldId="258"/>
            <ac:spMk id="27" creationId="{A0AD1BD8-E38F-8D5C-A4AC-EF13B80E7583}"/>
          </ac:spMkLst>
        </pc:spChg>
        <pc:spChg chg="mod">
          <ac:chgData name="Chloé Landry" userId="111132de-c275-47fc-8985-bc045a9ff9c7" providerId="ADAL" clId="{41F531ED-FF4C-51B2-842B-D1A21AF895D4}" dt="2026-02-06T22:27:12.057" v="839" actId="1076"/>
          <ac:spMkLst>
            <pc:docMk/>
            <pc:sldMk cId="2595074155" sldId="258"/>
            <ac:spMk id="29" creationId="{F2096323-CC67-147D-FCDB-0F33418E334C}"/>
          </ac:spMkLst>
        </pc:spChg>
        <pc:spChg chg="mod">
          <ac:chgData name="Chloé Landry" userId="111132de-c275-47fc-8985-bc045a9ff9c7" providerId="ADAL" clId="{41F531ED-FF4C-51B2-842B-D1A21AF895D4}" dt="2026-02-06T22:27:12.057" v="839" actId="1076"/>
          <ac:spMkLst>
            <pc:docMk/>
            <pc:sldMk cId="2595074155" sldId="258"/>
            <ac:spMk id="30" creationId="{E3DA2797-9931-240B-4828-18CCA9C65174}"/>
          </ac:spMkLst>
        </pc:spChg>
        <pc:spChg chg="mod">
          <ac:chgData name="Chloé Landry" userId="111132de-c275-47fc-8985-bc045a9ff9c7" providerId="ADAL" clId="{41F531ED-FF4C-51B2-842B-D1A21AF895D4}" dt="2026-02-06T22:26:58.816" v="838" actId="1038"/>
          <ac:spMkLst>
            <pc:docMk/>
            <pc:sldMk cId="2595074155" sldId="258"/>
            <ac:spMk id="31" creationId="{99F7D3F4-46A2-5BA7-CB98-263A64316772}"/>
          </ac:spMkLst>
        </pc:spChg>
        <pc:spChg chg="mod">
          <ac:chgData name="Chloé Landry" userId="111132de-c275-47fc-8985-bc045a9ff9c7" providerId="ADAL" clId="{41F531ED-FF4C-51B2-842B-D1A21AF895D4}" dt="2026-02-06T22:26:58.816" v="838" actId="1038"/>
          <ac:spMkLst>
            <pc:docMk/>
            <pc:sldMk cId="2595074155" sldId="258"/>
            <ac:spMk id="32" creationId="{00FDE92A-87F6-B675-88A0-F9C8C4C2BF0B}"/>
          </ac:spMkLst>
        </pc:spChg>
        <pc:spChg chg="mod">
          <ac:chgData name="Chloé Landry" userId="111132de-c275-47fc-8985-bc045a9ff9c7" providerId="ADAL" clId="{41F531ED-FF4C-51B2-842B-D1A21AF895D4}" dt="2026-02-06T22:26:58.816" v="838" actId="1038"/>
          <ac:spMkLst>
            <pc:docMk/>
            <pc:sldMk cId="2595074155" sldId="258"/>
            <ac:spMk id="33" creationId="{A1363BCB-E84D-620E-D9A5-D160CF88EF97}"/>
          </ac:spMkLst>
        </pc:spChg>
        <pc:spChg chg="mod">
          <ac:chgData name="Chloé Landry" userId="111132de-c275-47fc-8985-bc045a9ff9c7" providerId="ADAL" clId="{41F531ED-FF4C-51B2-842B-D1A21AF895D4}" dt="2026-02-06T22:26:58.816" v="838" actId="1038"/>
          <ac:spMkLst>
            <pc:docMk/>
            <pc:sldMk cId="2595074155" sldId="258"/>
            <ac:spMk id="34" creationId="{12C06BFC-0432-93EE-4AF4-20797AB643A1}"/>
          </ac:spMkLst>
        </pc:spChg>
        <pc:spChg chg="mod">
          <ac:chgData name="Chloé Landry" userId="111132de-c275-47fc-8985-bc045a9ff9c7" providerId="ADAL" clId="{41F531ED-FF4C-51B2-842B-D1A21AF895D4}" dt="2026-02-06T22:26:58.816" v="838" actId="1038"/>
          <ac:spMkLst>
            <pc:docMk/>
            <pc:sldMk cId="2595074155" sldId="258"/>
            <ac:spMk id="36" creationId="{1BF09D88-6FBE-9BAD-F2BF-8E4BB930AFDB}"/>
          </ac:spMkLst>
        </pc:spChg>
        <pc:picChg chg="mod">
          <ac:chgData name="Chloé Landry" userId="111132de-c275-47fc-8985-bc045a9ff9c7" providerId="ADAL" clId="{41F531ED-FF4C-51B2-842B-D1A21AF895D4}" dt="2026-02-06T22:26:58.816" v="838" actId="1038"/>
          <ac:picMkLst>
            <pc:docMk/>
            <pc:sldMk cId="2595074155" sldId="258"/>
            <ac:picMk id="4" creationId="{93926C3E-ADF8-C51E-EB3E-A6C1E280D10B}"/>
          </ac:picMkLst>
        </pc:picChg>
        <pc:picChg chg="mod">
          <ac:chgData name="Chloé Landry" userId="111132de-c275-47fc-8985-bc045a9ff9c7" providerId="ADAL" clId="{41F531ED-FF4C-51B2-842B-D1A21AF895D4}" dt="2026-02-06T22:27:12.057" v="839" actId="1076"/>
          <ac:picMkLst>
            <pc:docMk/>
            <pc:sldMk cId="2595074155" sldId="258"/>
            <ac:picMk id="5" creationId="{D58C9064-6680-F767-807D-ACAFA089F96A}"/>
          </ac:picMkLst>
        </pc:picChg>
        <pc:picChg chg="mod">
          <ac:chgData name="Chloé Landry" userId="111132de-c275-47fc-8985-bc045a9ff9c7" providerId="ADAL" clId="{41F531ED-FF4C-51B2-842B-D1A21AF895D4}" dt="2026-02-06T22:26:58.816" v="838" actId="1038"/>
          <ac:picMkLst>
            <pc:docMk/>
            <pc:sldMk cId="2595074155" sldId="258"/>
            <ac:picMk id="7" creationId="{6EE6A0F3-8741-25C6-23FD-D0262B25F150}"/>
          </ac:picMkLst>
        </pc:picChg>
        <pc:picChg chg="mod">
          <ac:chgData name="Chloé Landry" userId="111132de-c275-47fc-8985-bc045a9ff9c7" providerId="ADAL" clId="{41F531ED-FF4C-51B2-842B-D1A21AF895D4}" dt="2026-02-06T22:27:12.057" v="839" actId="1076"/>
          <ac:picMkLst>
            <pc:docMk/>
            <pc:sldMk cId="2595074155" sldId="258"/>
            <ac:picMk id="8" creationId="{264CB433-4E71-D009-DA75-1128AAD38EA4}"/>
          </ac:picMkLst>
        </pc:picChg>
        <pc:picChg chg="mod">
          <ac:chgData name="Chloé Landry" userId="111132de-c275-47fc-8985-bc045a9ff9c7" providerId="ADAL" clId="{41F531ED-FF4C-51B2-842B-D1A21AF895D4}" dt="2026-02-06T22:26:58.816" v="838" actId="1038"/>
          <ac:picMkLst>
            <pc:docMk/>
            <pc:sldMk cId="2595074155" sldId="258"/>
            <ac:picMk id="10" creationId="{F0E8A33C-3189-410D-3F66-3261E6A744AC}"/>
          </ac:picMkLst>
        </pc:picChg>
        <pc:picChg chg="mod">
          <ac:chgData name="Chloé Landry" userId="111132de-c275-47fc-8985-bc045a9ff9c7" providerId="ADAL" clId="{41F531ED-FF4C-51B2-842B-D1A21AF895D4}" dt="2026-02-06T22:26:58.816" v="838" actId="1038"/>
          <ac:picMkLst>
            <pc:docMk/>
            <pc:sldMk cId="2595074155" sldId="258"/>
            <ac:picMk id="13" creationId="{86C4181B-E94C-5C59-0FBE-F61A617D0711}"/>
          </ac:picMkLst>
        </pc:picChg>
        <pc:picChg chg="mod">
          <ac:chgData name="Chloé Landry" userId="111132de-c275-47fc-8985-bc045a9ff9c7" providerId="ADAL" clId="{41F531ED-FF4C-51B2-842B-D1A21AF895D4}" dt="2026-02-06T22:27:12.057" v="839" actId="1076"/>
          <ac:picMkLst>
            <pc:docMk/>
            <pc:sldMk cId="2595074155" sldId="258"/>
            <ac:picMk id="14" creationId="{5FD2E2EB-3092-DE2B-F759-7FE945DC0FC8}"/>
          </ac:picMkLst>
        </pc:picChg>
        <pc:picChg chg="mod">
          <ac:chgData name="Chloé Landry" userId="111132de-c275-47fc-8985-bc045a9ff9c7" providerId="ADAL" clId="{41F531ED-FF4C-51B2-842B-D1A21AF895D4}" dt="2026-02-06T22:26:58.816" v="838" actId="1038"/>
          <ac:picMkLst>
            <pc:docMk/>
            <pc:sldMk cId="2595074155" sldId="258"/>
            <ac:picMk id="16" creationId="{A7E6139D-EF70-AD83-CB51-947F4443A2D3}"/>
          </ac:picMkLst>
        </pc:picChg>
        <pc:picChg chg="mod">
          <ac:chgData name="Chloé Landry" userId="111132de-c275-47fc-8985-bc045a9ff9c7" providerId="ADAL" clId="{41F531ED-FF4C-51B2-842B-D1A21AF895D4}" dt="2026-02-06T22:27:12.057" v="839" actId="1076"/>
          <ac:picMkLst>
            <pc:docMk/>
            <pc:sldMk cId="2595074155" sldId="258"/>
            <ac:picMk id="17" creationId="{7518FC3F-5A5C-EB2B-69CA-07C9BBBEAA79}"/>
          </ac:picMkLst>
        </pc:picChg>
      </pc:sldChg>
      <pc:sldChg chg="addSp modSp del mod">
        <pc:chgData name="Chloé Landry" userId="111132de-c275-47fc-8985-bc045a9ff9c7" providerId="ADAL" clId="{41F531ED-FF4C-51B2-842B-D1A21AF895D4}" dt="2026-02-07T00:28:37.218" v="953" actId="2696"/>
        <pc:sldMkLst>
          <pc:docMk/>
          <pc:sldMk cId="2664825074" sldId="259"/>
        </pc:sldMkLst>
        <pc:spChg chg="mod">
          <ac:chgData name="Chloé Landry" userId="111132de-c275-47fc-8985-bc045a9ff9c7" providerId="ADAL" clId="{41F531ED-FF4C-51B2-842B-D1A21AF895D4}" dt="2026-02-07T00:10:07.498" v="919" actId="1076"/>
          <ac:spMkLst>
            <pc:docMk/>
            <pc:sldMk cId="2664825074" sldId="259"/>
            <ac:spMk id="10" creationId="{08A863CB-6E87-4313-181A-2555D85953EF}"/>
          </ac:spMkLst>
        </pc:spChg>
        <pc:spChg chg="add mod">
          <ac:chgData name="Chloé Landry" userId="111132de-c275-47fc-8985-bc045a9ff9c7" providerId="ADAL" clId="{41F531ED-FF4C-51B2-842B-D1A21AF895D4}" dt="2026-02-06T19:53:42.106" v="720" actId="1076"/>
          <ac:spMkLst>
            <pc:docMk/>
            <pc:sldMk cId="2664825074" sldId="259"/>
            <ac:spMk id="14" creationId="{AD7328F2-217D-ABDB-CE37-391C40EEBFA7}"/>
          </ac:spMkLst>
        </pc:spChg>
      </pc:sldChg>
      <pc:sldChg chg="del">
        <pc:chgData name="Chloé Landry" userId="111132de-c275-47fc-8985-bc045a9ff9c7" providerId="ADAL" clId="{41F531ED-FF4C-51B2-842B-D1A21AF895D4}" dt="2026-02-06T21:15:44.845" v="721" actId="2696"/>
        <pc:sldMkLst>
          <pc:docMk/>
          <pc:sldMk cId="443727691" sldId="260"/>
        </pc:sldMkLst>
      </pc:sldChg>
      <pc:sldChg chg="modSp del mod">
        <pc:chgData name="Chloé Landry" userId="111132de-c275-47fc-8985-bc045a9ff9c7" providerId="ADAL" clId="{41F531ED-FF4C-51B2-842B-D1A21AF895D4}" dt="2026-02-07T00:24:55.403" v="951" actId="2696"/>
        <pc:sldMkLst>
          <pc:docMk/>
          <pc:sldMk cId="2351317433" sldId="261"/>
        </pc:sldMkLst>
        <pc:spChg chg="mod">
          <ac:chgData name="Chloé Landry" userId="111132de-c275-47fc-8985-bc045a9ff9c7" providerId="ADAL" clId="{41F531ED-FF4C-51B2-842B-D1A21AF895D4}" dt="2026-02-07T00:08:39.735" v="913" actId="14100"/>
          <ac:spMkLst>
            <pc:docMk/>
            <pc:sldMk cId="2351317433" sldId="261"/>
            <ac:spMk id="2" creationId="{6D407346-9674-EB42-4080-0038DE2048C6}"/>
          </ac:spMkLst>
        </pc:spChg>
      </pc:sldChg>
      <pc:sldChg chg="modSp mod">
        <pc:chgData name="Chloé Landry" userId="111132de-c275-47fc-8985-bc045a9ff9c7" providerId="ADAL" clId="{41F531ED-FF4C-51B2-842B-D1A21AF895D4}" dt="2026-02-06T21:16:47.837" v="748" actId="20577"/>
        <pc:sldMkLst>
          <pc:docMk/>
          <pc:sldMk cId="877368732" sldId="262"/>
        </pc:sldMkLst>
        <pc:spChg chg="mod">
          <ac:chgData name="Chloé Landry" userId="111132de-c275-47fc-8985-bc045a9ff9c7" providerId="ADAL" clId="{41F531ED-FF4C-51B2-842B-D1A21AF895D4}" dt="2026-02-06T21:16:47.837" v="748" actId="20577"/>
          <ac:spMkLst>
            <pc:docMk/>
            <pc:sldMk cId="877368732" sldId="262"/>
            <ac:spMk id="9" creationId="{6CEE59E0-F0E8-95AD-DC8B-4AEAED4C66B9}"/>
          </ac:spMkLst>
        </pc:spChg>
      </pc:sldChg>
      <pc:sldChg chg="modSp del mod">
        <pc:chgData name="Chloé Landry" userId="111132de-c275-47fc-8985-bc045a9ff9c7" providerId="ADAL" clId="{41F531ED-FF4C-51B2-842B-D1A21AF895D4}" dt="2026-02-07T00:24:55.403" v="951" actId="2696"/>
        <pc:sldMkLst>
          <pc:docMk/>
          <pc:sldMk cId="1463528531" sldId="263"/>
        </pc:sldMkLst>
        <pc:spChg chg="mod">
          <ac:chgData name="Chloé Landry" userId="111132de-c275-47fc-8985-bc045a9ff9c7" providerId="ADAL" clId="{41F531ED-FF4C-51B2-842B-D1A21AF895D4}" dt="2026-02-06T22:37:05.772" v="891" actId="20577"/>
          <ac:spMkLst>
            <pc:docMk/>
            <pc:sldMk cId="1463528531" sldId="263"/>
            <ac:spMk id="2" creationId="{08F2242C-4AB4-8019-E992-2727FB82F929}"/>
          </ac:spMkLst>
        </pc:spChg>
        <pc:spChg chg="mod">
          <ac:chgData name="Chloé Landry" userId="111132de-c275-47fc-8985-bc045a9ff9c7" providerId="ADAL" clId="{41F531ED-FF4C-51B2-842B-D1A21AF895D4}" dt="2026-02-06T22:37:08.519" v="893" actId="20577"/>
          <ac:spMkLst>
            <pc:docMk/>
            <pc:sldMk cId="1463528531" sldId="263"/>
            <ac:spMk id="3" creationId="{FE3ADAB5-795C-3776-F853-7878D19DA346}"/>
          </ac:spMkLst>
        </pc:spChg>
      </pc:sldChg>
      <pc:sldChg chg="modSp del mod">
        <pc:chgData name="Chloé Landry" userId="111132de-c275-47fc-8985-bc045a9ff9c7" providerId="ADAL" clId="{41F531ED-FF4C-51B2-842B-D1A21AF895D4}" dt="2026-02-07T00:24:55.403" v="951" actId="2696"/>
        <pc:sldMkLst>
          <pc:docMk/>
          <pc:sldMk cId="2833800643" sldId="264"/>
        </pc:sldMkLst>
        <pc:spChg chg="mod">
          <ac:chgData name="Chloé Landry" userId="111132de-c275-47fc-8985-bc045a9ff9c7" providerId="ADAL" clId="{41F531ED-FF4C-51B2-842B-D1A21AF895D4}" dt="2026-02-07T00:06:15.493" v="911" actId="1076"/>
          <ac:spMkLst>
            <pc:docMk/>
            <pc:sldMk cId="2833800643" sldId="264"/>
            <ac:spMk id="52" creationId="{A492B946-7F5A-E318-3D6E-4F45FD158C3E}"/>
          </ac:spMkLst>
        </pc:spChg>
      </pc:sldChg>
      <pc:sldChg chg="del">
        <pc:chgData name="Chloé Landry" userId="111132de-c275-47fc-8985-bc045a9ff9c7" providerId="ADAL" clId="{41F531ED-FF4C-51B2-842B-D1A21AF895D4}" dt="2026-02-07T00:24:55.403" v="951" actId="2696"/>
        <pc:sldMkLst>
          <pc:docMk/>
          <pc:sldMk cId="907146193" sldId="265"/>
        </pc:sldMkLst>
      </pc:sldChg>
      <pc:sldChg chg="modSp add del mod">
        <pc:chgData name="Chloé Landry" userId="111132de-c275-47fc-8985-bc045a9ff9c7" providerId="ADAL" clId="{41F531ED-FF4C-51B2-842B-D1A21AF895D4}" dt="2026-02-07T00:28:37.218" v="953" actId="2696"/>
        <pc:sldMkLst>
          <pc:docMk/>
          <pc:sldMk cId="2888321743" sldId="266"/>
        </pc:sldMkLst>
        <pc:spChg chg="mod">
          <ac:chgData name="Chloé Landry" userId="111132de-c275-47fc-8985-bc045a9ff9c7" providerId="ADAL" clId="{41F531ED-FF4C-51B2-842B-D1A21AF895D4}" dt="2026-02-07T00:09:27.601" v="915" actId="5736"/>
          <ac:spMkLst>
            <pc:docMk/>
            <pc:sldMk cId="2888321743" sldId="266"/>
            <ac:spMk id="2" creationId="{7BECF8F9-D84E-BF0D-BFC8-551410B2B712}"/>
          </ac:spMkLst>
        </pc:spChg>
        <pc:spChg chg="mod">
          <ac:chgData name="Chloé Landry" userId="111132de-c275-47fc-8985-bc045a9ff9c7" providerId="ADAL" clId="{41F531ED-FF4C-51B2-842B-D1A21AF895D4}" dt="2026-02-07T00:09:27.601" v="915" actId="5736"/>
          <ac:spMkLst>
            <pc:docMk/>
            <pc:sldMk cId="2888321743" sldId="266"/>
            <ac:spMk id="208" creationId="{8B16FB54-B91F-F77E-141A-37A24EFAF520}"/>
          </ac:spMkLst>
        </pc:spChg>
        <pc:spChg chg="mod">
          <ac:chgData name="Chloé Landry" userId="111132de-c275-47fc-8985-bc045a9ff9c7" providerId="ADAL" clId="{41F531ED-FF4C-51B2-842B-D1A21AF895D4}" dt="2026-02-07T00:09:27.601" v="915" actId="5736"/>
          <ac:spMkLst>
            <pc:docMk/>
            <pc:sldMk cId="2888321743" sldId="266"/>
            <ac:spMk id="209" creationId="{F461A29C-0054-08A1-DA05-8383FAFF5BFE}"/>
          </ac:spMkLst>
        </pc:spChg>
        <pc:spChg chg="mod">
          <ac:chgData name="Chloé Landry" userId="111132de-c275-47fc-8985-bc045a9ff9c7" providerId="ADAL" clId="{41F531ED-FF4C-51B2-842B-D1A21AF895D4}" dt="2026-02-07T00:09:27.601" v="915" actId="5736"/>
          <ac:spMkLst>
            <pc:docMk/>
            <pc:sldMk cId="2888321743" sldId="266"/>
            <ac:spMk id="210" creationId="{C1BDAE6F-4007-55A6-0F5A-C0B22C51B520}"/>
          </ac:spMkLst>
        </pc:spChg>
        <pc:spChg chg="mod">
          <ac:chgData name="Chloé Landry" userId="111132de-c275-47fc-8985-bc045a9ff9c7" providerId="ADAL" clId="{41F531ED-FF4C-51B2-842B-D1A21AF895D4}" dt="2026-02-07T00:09:27.601" v="915" actId="5736"/>
          <ac:spMkLst>
            <pc:docMk/>
            <pc:sldMk cId="2888321743" sldId="266"/>
            <ac:spMk id="211" creationId="{59BAE027-7389-3861-1922-61DA3B63F166}"/>
          </ac:spMkLst>
        </pc:spChg>
        <pc:picChg chg="mod">
          <ac:chgData name="Chloé Landry" userId="111132de-c275-47fc-8985-bc045a9ff9c7" providerId="ADAL" clId="{41F531ED-FF4C-51B2-842B-D1A21AF895D4}" dt="2026-02-07T00:09:27.601" v="915" actId="5736"/>
          <ac:picMkLst>
            <pc:docMk/>
            <pc:sldMk cId="2888321743" sldId="266"/>
            <ac:picMk id="50" creationId="{1C07CE2D-C2A4-44A0-1D8E-C1CDD2CC0C8B}"/>
          </ac:picMkLst>
        </pc:picChg>
        <pc:picChg chg="mod">
          <ac:chgData name="Chloé Landry" userId="111132de-c275-47fc-8985-bc045a9ff9c7" providerId="ADAL" clId="{41F531ED-FF4C-51B2-842B-D1A21AF895D4}" dt="2026-02-07T00:09:27.601" v="915" actId="5736"/>
          <ac:picMkLst>
            <pc:docMk/>
            <pc:sldMk cId="2888321743" sldId="266"/>
            <ac:picMk id="70" creationId="{9EC64FF9-7EF7-D16D-7CE9-5940BB903646}"/>
          </ac:picMkLst>
        </pc:picChg>
        <pc:picChg chg="mod">
          <ac:chgData name="Chloé Landry" userId="111132de-c275-47fc-8985-bc045a9ff9c7" providerId="ADAL" clId="{41F531ED-FF4C-51B2-842B-D1A21AF895D4}" dt="2026-02-07T00:09:27.601" v="915" actId="5736"/>
          <ac:picMkLst>
            <pc:docMk/>
            <pc:sldMk cId="2888321743" sldId="266"/>
            <ac:picMk id="153" creationId="{285AD3F1-7DAD-2A0B-E78F-F70D73306A40}"/>
          </ac:picMkLst>
        </pc:picChg>
        <pc:picChg chg="mod">
          <ac:chgData name="Chloé Landry" userId="111132de-c275-47fc-8985-bc045a9ff9c7" providerId="ADAL" clId="{41F531ED-FF4C-51B2-842B-D1A21AF895D4}" dt="2026-02-07T00:09:27.601" v="915" actId="5736"/>
          <ac:picMkLst>
            <pc:docMk/>
            <pc:sldMk cId="2888321743" sldId="266"/>
            <ac:picMk id="163" creationId="{53500912-CD84-BE18-E0A3-B1B098B0633A}"/>
          </ac:picMkLst>
        </pc:picChg>
        <pc:picChg chg="mod">
          <ac:chgData name="Chloé Landry" userId="111132de-c275-47fc-8985-bc045a9ff9c7" providerId="ADAL" clId="{41F531ED-FF4C-51B2-842B-D1A21AF895D4}" dt="2026-02-07T00:09:27.601" v="915" actId="5736"/>
          <ac:picMkLst>
            <pc:docMk/>
            <pc:sldMk cId="2888321743" sldId="266"/>
            <ac:picMk id="173" creationId="{4E13F436-A143-A65A-0A92-1E0137AD8FD1}"/>
          </ac:picMkLst>
        </pc:picChg>
      </pc:sldChg>
      <pc:sldChg chg="modSp mod">
        <pc:chgData name="Chloé Landry" userId="111132de-c275-47fc-8985-bc045a9ff9c7" providerId="ADAL" clId="{41F531ED-FF4C-51B2-842B-D1A21AF895D4}" dt="2026-02-07T00:12:51.031" v="945" actId="14100"/>
        <pc:sldMkLst>
          <pc:docMk/>
          <pc:sldMk cId="1247179969" sldId="267"/>
        </pc:sldMkLst>
        <pc:spChg chg="mod">
          <ac:chgData name="Chloé Landry" userId="111132de-c275-47fc-8985-bc045a9ff9c7" providerId="ADAL" clId="{41F531ED-FF4C-51B2-842B-D1A21AF895D4}" dt="2026-02-07T00:12:51.031" v="945" actId="14100"/>
          <ac:spMkLst>
            <pc:docMk/>
            <pc:sldMk cId="1247179969" sldId="267"/>
            <ac:spMk id="3" creationId="{25A74E1D-2C2B-1A56-9968-0F2636681345}"/>
          </ac:spMkLst>
        </pc:spChg>
      </pc:sldChg>
      <pc:sldChg chg="addSp delSp modSp mod">
        <pc:chgData name="Chloé Landry" userId="111132de-c275-47fc-8985-bc045a9ff9c7" providerId="ADAL" clId="{41F531ED-FF4C-51B2-842B-D1A21AF895D4}" dt="2026-02-06T22:37:53.044" v="909" actId="20577"/>
        <pc:sldMkLst>
          <pc:docMk/>
          <pc:sldMk cId="4262463860" sldId="268"/>
        </pc:sldMkLst>
        <pc:spChg chg="mod">
          <ac:chgData name="Chloé Landry" userId="111132de-c275-47fc-8985-bc045a9ff9c7" providerId="ADAL" clId="{41F531ED-FF4C-51B2-842B-D1A21AF895D4}" dt="2026-02-06T22:37:45.197" v="903" actId="20577"/>
          <ac:spMkLst>
            <pc:docMk/>
            <pc:sldMk cId="4262463860" sldId="268"/>
            <ac:spMk id="2" creationId="{516EA4C3-9B3C-686C-05D7-EEF2E0B1A22C}"/>
          </ac:spMkLst>
        </pc:spChg>
        <pc:spChg chg="mod">
          <ac:chgData name="Chloé Landry" userId="111132de-c275-47fc-8985-bc045a9ff9c7" providerId="ADAL" clId="{41F531ED-FF4C-51B2-842B-D1A21AF895D4}" dt="2026-02-06T22:37:48.540" v="905" actId="20577"/>
          <ac:spMkLst>
            <pc:docMk/>
            <pc:sldMk cId="4262463860" sldId="268"/>
            <ac:spMk id="4" creationId="{DF52450D-A471-B082-9DE2-8A91AD66071F}"/>
          </ac:spMkLst>
        </pc:spChg>
        <pc:spChg chg="mod">
          <ac:chgData name="Chloé Landry" userId="111132de-c275-47fc-8985-bc045a9ff9c7" providerId="ADAL" clId="{41F531ED-FF4C-51B2-842B-D1A21AF895D4}" dt="2026-02-06T22:37:50.912" v="907" actId="20577"/>
          <ac:spMkLst>
            <pc:docMk/>
            <pc:sldMk cId="4262463860" sldId="268"/>
            <ac:spMk id="7" creationId="{7C6B6172-DA90-EAE7-70B6-49583954E0EF}"/>
          </ac:spMkLst>
        </pc:spChg>
        <pc:spChg chg="mod">
          <ac:chgData name="Chloé Landry" userId="111132de-c275-47fc-8985-bc045a9ff9c7" providerId="ADAL" clId="{41F531ED-FF4C-51B2-842B-D1A21AF895D4}" dt="2026-02-06T22:37:53.044" v="909" actId="20577"/>
          <ac:spMkLst>
            <pc:docMk/>
            <pc:sldMk cId="4262463860" sldId="268"/>
            <ac:spMk id="8" creationId="{C8363715-E9AC-2BB0-B8CA-E042C8438F21}"/>
          </ac:spMkLst>
        </pc:spChg>
        <pc:spChg chg="mod">
          <ac:chgData name="Chloé Landry" userId="111132de-c275-47fc-8985-bc045a9ff9c7" providerId="ADAL" clId="{41F531ED-FF4C-51B2-842B-D1A21AF895D4}" dt="2026-02-06T21:16:27.109" v="740" actId="20577"/>
          <ac:spMkLst>
            <pc:docMk/>
            <pc:sldMk cId="4262463860" sldId="268"/>
            <ac:spMk id="16" creationId="{737B0FBD-0DF8-073F-B90E-B19EA9C420AB}"/>
          </ac:spMkLst>
        </pc:spChg>
        <pc:spChg chg="mod">
          <ac:chgData name="Chloé Landry" userId="111132de-c275-47fc-8985-bc045a9ff9c7" providerId="ADAL" clId="{41F531ED-FF4C-51B2-842B-D1A21AF895D4}" dt="2026-02-06T22:28:01.510" v="844" actId="1076"/>
          <ac:spMkLst>
            <pc:docMk/>
            <pc:sldMk cId="4262463860" sldId="268"/>
            <ac:spMk id="17" creationId="{515DA48E-6CCB-D9F0-1A56-179BC75F0553}"/>
          </ac:spMkLst>
        </pc:spChg>
        <pc:spChg chg="mod">
          <ac:chgData name="Chloé Landry" userId="111132de-c275-47fc-8985-bc045a9ff9c7" providerId="ADAL" clId="{41F531ED-FF4C-51B2-842B-D1A21AF895D4}" dt="2026-02-06T22:27:54.311" v="843" actId="1076"/>
          <ac:spMkLst>
            <pc:docMk/>
            <pc:sldMk cId="4262463860" sldId="268"/>
            <ac:spMk id="18" creationId="{BA3C853B-107C-8BC9-E075-6D8EE961CC00}"/>
          </ac:spMkLst>
        </pc:spChg>
        <pc:spChg chg="mod">
          <ac:chgData name="Chloé Landry" userId="111132de-c275-47fc-8985-bc045a9ff9c7" providerId="ADAL" clId="{41F531ED-FF4C-51B2-842B-D1A21AF895D4}" dt="2026-02-06T22:28:01.510" v="844" actId="1076"/>
          <ac:spMkLst>
            <pc:docMk/>
            <pc:sldMk cId="4262463860" sldId="268"/>
            <ac:spMk id="19" creationId="{F94E7401-6C19-6DB7-617A-3389242325F6}"/>
          </ac:spMkLst>
        </pc:spChg>
        <pc:spChg chg="mod">
          <ac:chgData name="Chloé Landry" userId="111132de-c275-47fc-8985-bc045a9ff9c7" providerId="ADAL" clId="{41F531ED-FF4C-51B2-842B-D1A21AF895D4}" dt="2026-02-06T22:28:01.510" v="844" actId="1076"/>
          <ac:spMkLst>
            <pc:docMk/>
            <pc:sldMk cId="4262463860" sldId="268"/>
            <ac:spMk id="20" creationId="{14489CED-6632-F0A2-8A43-3D61AD5B92B1}"/>
          </ac:spMkLst>
        </pc:spChg>
        <pc:spChg chg="mod">
          <ac:chgData name="Chloé Landry" userId="111132de-c275-47fc-8985-bc045a9ff9c7" providerId="ADAL" clId="{41F531ED-FF4C-51B2-842B-D1A21AF895D4}" dt="2026-02-06T22:28:01.510" v="844" actId="1076"/>
          <ac:spMkLst>
            <pc:docMk/>
            <pc:sldMk cId="4262463860" sldId="268"/>
            <ac:spMk id="21" creationId="{C21D7CEB-50DC-E04E-1763-2DCB58603592}"/>
          </ac:spMkLst>
        </pc:spChg>
        <pc:spChg chg="mod">
          <ac:chgData name="Chloé Landry" userId="111132de-c275-47fc-8985-bc045a9ff9c7" providerId="ADAL" clId="{41F531ED-FF4C-51B2-842B-D1A21AF895D4}" dt="2026-02-06T22:27:54.311" v="843" actId="1076"/>
          <ac:spMkLst>
            <pc:docMk/>
            <pc:sldMk cId="4262463860" sldId="268"/>
            <ac:spMk id="22" creationId="{40E76A30-71C2-5804-92C3-BA30691D37B2}"/>
          </ac:spMkLst>
        </pc:spChg>
        <pc:spChg chg="mod">
          <ac:chgData name="Chloé Landry" userId="111132de-c275-47fc-8985-bc045a9ff9c7" providerId="ADAL" clId="{41F531ED-FF4C-51B2-842B-D1A21AF895D4}" dt="2026-02-06T22:27:54.311" v="843" actId="1076"/>
          <ac:spMkLst>
            <pc:docMk/>
            <pc:sldMk cId="4262463860" sldId="268"/>
            <ac:spMk id="23" creationId="{068BED47-FE40-F84B-7228-E2CDE739227A}"/>
          </ac:spMkLst>
        </pc:spChg>
        <pc:spChg chg="mod">
          <ac:chgData name="Chloé Landry" userId="111132de-c275-47fc-8985-bc045a9ff9c7" providerId="ADAL" clId="{41F531ED-FF4C-51B2-842B-D1A21AF895D4}" dt="2026-02-06T22:27:54.311" v="843" actId="1076"/>
          <ac:spMkLst>
            <pc:docMk/>
            <pc:sldMk cId="4262463860" sldId="268"/>
            <ac:spMk id="24" creationId="{247B0C79-34A4-072F-39EC-5793B0ECCD8F}"/>
          </ac:spMkLst>
        </pc:spChg>
        <pc:picChg chg="mod">
          <ac:chgData name="Chloé Landry" userId="111132de-c275-47fc-8985-bc045a9ff9c7" providerId="ADAL" clId="{41F531ED-FF4C-51B2-842B-D1A21AF895D4}" dt="2026-02-06T22:28:01.510" v="844" actId="1076"/>
          <ac:picMkLst>
            <pc:docMk/>
            <pc:sldMk cId="4262463860" sldId="268"/>
            <ac:picMk id="3" creationId="{28F2CB3F-884D-A188-CF71-96765E3CF9B3}"/>
          </ac:picMkLst>
        </pc:picChg>
        <pc:picChg chg="mod">
          <ac:chgData name="Chloé Landry" userId="111132de-c275-47fc-8985-bc045a9ff9c7" providerId="ADAL" clId="{41F531ED-FF4C-51B2-842B-D1A21AF895D4}" dt="2026-02-06T22:27:54.311" v="843" actId="1076"/>
          <ac:picMkLst>
            <pc:docMk/>
            <pc:sldMk cId="4262463860" sldId="268"/>
            <ac:picMk id="5" creationId="{37348A10-BB87-1DBA-C35C-9D41C0D64D65}"/>
          </ac:picMkLst>
        </pc:picChg>
        <pc:picChg chg="mod">
          <ac:chgData name="Chloé Landry" userId="111132de-c275-47fc-8985-bc045a9ff9c7" providerId="ADAL" clId="{41F531ED-FF4C-51B2-842B-D1A21AF895D4}" dt="2026-02-06T22:27:54.311" v="843" actId="1076"/>
          <ac:picMkLst>
            <pc:docMk/>
            <pc:sldMk cId="4262463860" sldId="268"/>
            <ac:picMk id="9" creationId="{92C269AA-2AD1-058A-87E6-8F71FED7527F}"/>
          </ac:picMkLst>
        </pc:picChg>
        <pc:picChg chg="mod">
          <ac:chgData name="Chloé Landry" userId="111132de-c275-47fc-8985-bc045a9ff9c7" providerId="ADAL" clId="{41F531ED-FF4C-51B2-842B-D1A21AF895D4}" dt="2026-02-06T22:28:01.510" v="844" actId="1076"/>
          <ac:picMkLst>
            <pc:docMk/>
            <pc:sldMk cId="4262463860" sldId="268"/>
            <ac:picMk id="10" creationId="{E4496929-2237-646C-BA8E-14A7F879814E}"/>
          </ac:picMkLst>
        </pc:picChg>
        <pc:picChg chg="mod">
          <ac:chgData name="Chloé Landry" userId="111132de-c275-47fc-8985-bc045a9ff9c7" providerId="ADAL" clId="{41F531ED-FF4C-51B2-842B-D1A21AF895D4}" dt="2026-02-06T22:28:01.510" v="844" actId="1076"/>
          <ac:picMkLst>
            <pc:docMk/>
            <pc:sldMk cId="4262463860" sldId="268"/>
            <ac:picMk id="11" creationId="{F9FF1690-B8E4-CD19-9F0A-7824F4B4AE40}"/>
          </ac:picMkLst>
        </pc:picChg>
        <pc:picChg chg="mod">
          <ac:chgData name="Chloé Landry" userId="111132de-c275-47fc-8985-bc045a9ff9c7" providerId="ADAL" clId="{41F531ED-FF4C-51B2-842B-D1A21AF895D4}" dt="2026-02-06T22:27:54.311" v="843" actId="1076"/>
          <ac:picMkLst>
            <pc:docMk/>
            <pc:sldMk cId="4262463860" sldId="268"/>
            <ac:picMk id="13" creationId="{5A8A150C-3EE4-7B9B-1E15-5B4C8DE946E3}"/>
          </ac:picMkLst>
        </pc:picChg>
        <pc:picChg chg="mod">
          <ac:chgData name="Chloé Landry" userId="111132de-c275-47fc-8985-bc045a9ff9c7" providerId="ADAL" clId="{41F531ED-FF4C-51B2-842B-D1A21AF895D4}" dt="2026-02-06T22:28:01.510" v="844" actId="1076"/>
          <ac:picMkLst>
            <pc:docMk/>
            <pc:sldMk cId="4262463860" sldId="268"/>
            <ac:picMk id="15" creationId="{6B082552-2B8E-4D02-8395-440E13C30508}"/>
          </ac:picMkLst>
        </pc:picChg>
      </pc:sldChg>
      <pc:sldChg chg="modSp mod">
        <pc:chgData name="Chloé Landry" userId="111132de-c275-47fc-8985-bc045a9ff9c7" providerId="ADAL" clId="{41F531ED-FF4C-51B2-842B-D1A21AF895D4}" dt="2026-02-07T00:13:37.348" v="946" actId="5736"/>
        <pc:sldMkLst>
          <pc:docMk/>
          <pc:sldMk cId="3298780960" sldId="269"/>
        </pc:sldMkLst>
        <pc:spChg chg="mod">
          <ac:chgData name="Chloé Landry" userId="111132de-c275-47fc-8985-bc045a9ff9c7" providerId="ADAL" clId="{41F531ED-FF4C-51B2-842B-D1A21AF895D4}" dt="2026-02-07T00:13:37.348" v="946" actId="5736"/>
          <ac:spMkLst>
            <pc:docMk/>
            <pc:sldMk cId="3298780960" sldId="269"/>
            <ac:spMk id="57" creationId="{4D546C9C-D848-2369-080F-0FCAEA9050C9}"/>
          </ac:spMkLst>
        </pc:sp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3" creationId="{3F8CE384-A006-1822-90F6-5E9BDF009B95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5" creationId="{747454A2-8B81-3E2C-5664-C27C9F6F8274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10" creationId="{9D8BC022-53F9-7CD4-F4F9-1EB6AE1A8835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14" creationId="{479E63FF-DBF4-F36C-3EA4-3126AB147D15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16" creationId="{3410CB38-A6C6-0C5C-7D77-EBB74BAABA2B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17" creationId="{7C139EFC-C8B5-C2B7-2E5F-2B5694863C04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20" creationId="{4253EE77-173F-01DA-9FDC-754B8B47E39E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25" creationId="{702C46E3-1DEE-4355-DC36-ECECBA1BB217}"/>
          </ac:picMkLst>
        </pc:picChg>
        <pc:picChg chg="mod">
          <ac:chgData name="Chloé Landry" userId="111132de-c275-47fc-8985-bc045a9ff9c7" providerId="ADAL" clId="{41F531ED-FF4C-51B2-842B-D1A21AF895D4}" dt="2026-02-07T00:13:37.348" v="946" actId="5736"/>
          <ac:picMkLst>
            <pc:docMk/>
            <pc:sldMk cId="3298780960" sldId="269"/>
            <ac:picMk id="31" creationId="{33EDF445-E729-B6C2-6CC8-01B312825A3C}"/>
          </ac:picMkLst>
        </pc:picChg>
      </pc:sldChg>
      <pc:sldChg chg="modSp del mod">
        <pc:chgData name="Chloé Landry" userId="111132de-c275-47fc-8985-bc045a9ff9c7" providerId="ADAL" clId="{41F531ED-FF4C-51B2-842B-D1A21AF895D4}" dt="2026-02-07T00:28:37.218" v="953" actId="2696"/>
        <pc:sldMkLst>
          <pc:docMk/>
          <pc:sldMk cId="3415687839" sldId="270"/>
        </pc:sldMkLst>
        <pc:spChg chg="mod">
          <ac:chgData name="Chloé Landry" userId="111132de-c275-47fc-8985-bc045a9ff9c7" providerId="ADAL" clId="{41F531ED-FF4C-51B2-842B-D1A21AF895D4}" dt="2026-02-07T00:11:53.708" v="944" actId="1035"/>
          <ac:spMkLst>
            <pc:docMk/>
            <pc:sldMk cId="3415687839" sldId="270"/>
            <ac:spMk id="3" creationId="{6F8A0B88-0E92-F2C6-4EFE-44CAC2E45C27}"/>
          </ac:spMkLst>
        </pc:spChg>
        <pc:spChg chg="mod">
          <ac:chgData name="Chloé Landry" userId="111132de-c275-47fc-8985-bc045a9ff9c7" providerId="ADAL" clId="{41F531ED-FF4C-51B2-842B-D1A21AF895D4}" dt="2026-02-07T00:11:33.138" v="933" actId="255"/>
          <ac:spMkLst>
            <pc:docMk/>
            <pc:sldMk cId="3415687839" sldId="270"/>
            <ac:spMk id="4" creationId="{A6FF094C-40E4-4B80-2CE8-89EFBD2B8B1C}"/>
          </ac:spMkLst>
        </pc:spChg>
        <pc:spChg chg="mod">
          <ac:chgData name="Chloé Landry" userId="111132de-c275-47fc-8985-bc045a9ff9c7" providerId="ADAL" clId="{41F531ED-FF4C-51B2-842B-D1A21AF895D4}" dt="2026-02-07T00:11:37.729" v="934" actId="255"/>
          <ac:spMkLst>
            <pc:docMk/>
            <pc:sldMk cId="3415687839" sldId="270"/>
            <ac:spMk id="5" creationId="{12D8E680-CD49-5613-DF94-6E87D0CC8BAF}"/>
          </ac:spMkLst>
        </pc:spChg>
        <pc:spChg chg="mod">
          <ac:chgData name="Chloé Landry" userId="111132de-c275-47fc-8985-bc045a9ff9c7" providerId="ADAL" clId="{41F531ED-FF4C-51B2-842B-D1A21AF895D4}" dt="2026-02-07T00:11:42.289" v="935" actId="255"/>
          <ac:spMkLst>
            <pc:docMk/>
            <pc:sldMk cId="3415687839" sldId="270"/>
            <ac:spMk id="6" creationId="{468A5A87-9603-CCEA-019C-68E7B752F71B}"/>
          </ac:spMkLst>
        </pc:spChg>
        <pc:spChg chg="mod">
          <ac:chgData name="Chloé Landry" userId="111132de-c275-47fc-8985-bc045a9ff9c7" providerId="ADAL" clId="{41F531ED-FF4C-51B2-842B-D1A21AF895D4}" dt="2026-02-07T00:11:47.349" v="936" actId="255"/>
          <ac:spMkLst>
            <pc:docMk/>
            <pc:sldMk cId="3415687839" sldId="270"/>
            <ac:spMk id="50" creationId="{9974F337-2C29-2D03-DFA0-FBC90D72355B}"/>
          </ac:spMkLst>
        </pc:spChg>
      </pc:sldChg>
      <pc:sldChg chg="modSp del mod">
        <pc:chgData name="Chloé Landry" userId="111132de-c275-47fc-8985-bc045a9ff9c7" providerId="ADAL" clId="{41F531ED-FF4C-51B2-842B-D1A21AF895D4}" dt="2026-02-07T00:28:37.218" v="953" actId="2696"/>
        <pc:sldMkLst>
          <pc:docMk/>
          <pc:sldMk cId="4274202175" sldId="271"/>
        </pc:sldMkLst>
        <pc:spChg chg="mod">
          <ac:chgData name="Chloé Landry" userId="111132de-c275-47fc-8985-bc045a9ff9c7" providerId="ADAL" clId="{41F531ED-FF4C-51B2-842B-D1A21AF895D4}" dt="2026-02-06T22:37:27.648" v="899" actId="20577"/>
          <ac:spMkLst>
            <pc:docMk/>
            <pc:sldMk cId="4274202175" sldId="271"/>
            <ac:spMk id="18" creationId="{6A1BC289-5392-C693-59F3-40B252923C6D}"/>
          </ac:spMkLst>
        </pc:spChg>
        <pc:spChg chg="mod">
          <ac:chgData name="Chloé Landry" userId="111132de-c275-47fc-8985-bc045a9ff9c7" providerId="ADAL" clId="{41F531ED-FF4C-51B2-842B-D1A21AF895D4}" dt="2026-02-06T22:37:30.617" v="901" actId="20577"/>
          <ac:spMkLst>
            <pc:docMk/>
            <pc:sldMk cId="4274202175" sldId="271"/>
            <ac:spMk id="19" creationId="{F4903594-59C3-1598-CB00-C3148050F10C}"/>
          </ac:spMkLst>
        </pc:spChg>
        <pc:spChg chg="mod">
          <ac:chgData name="Chloé Landry" userId="111132de-c275-47fc-8985-bc045a9ff9c7" providerId="ADAL" clId="{41F531ED-FF4C-51B2-842B-D1A21AF895D4}" dt="2026-02-07T00:09:38.685" v="918" actId="1038"/>
          <ac:spMkLst>
            <pc:docMk/>
            <pc:sldMk cId="4274202175" sldId="271"/>
            <ac:spMk id="20" creationId="{A46272D5-94C6-0DCA-0CEB-C7ECA62A4CA4}"/>
          </ac:spMkLst>
        </pc:spChg>
      </pc:sldChg>
      <pc:sldChg chg="modSp mod">
        <pc:chgData name="Chloé Landry" userId="111132de-c275-47fc-8985-bc045a9ff9c7" providerId="ADAL" clId="{41F531ED-FF4C-51B2-842B-D1A21AF895D4}" dt="2026-02-06T21:16:44.037" v="746" actId="20577"/>
        <pc:sldMkLst>
          <pc:docMk/>
          <pc:sldMk cId="489340006" sldId="272"/>
        </pc:sldMkLst>
        <pc:spChg chg="mod">
          <ac:chgData name="Chloé Landry" userId="111132de-c275-47fc-8985-bc045a9ff9c7" providerId="ADAL" clId="{41F531ED-FF4C-51B2-842B-D1A21AF895D4}" dt="2026-02-06T21:16:44.037" v="746" actId="20577"/>
          <ac:spMkLst>
            <pc:docMk/>
            <pc:sldMk cId="489340006" sldId="272"/>
            <ac:spMk id="7" creationId="{C0A531A1-FB91-EB7E-C32D-C2AEF886663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CE6993-3C46-6746-8098-FBD71665A923}" type="datetimeFigureOut">
              <a:rPr lang="en-US" smtClean="0"/>
              <a:t>2/6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0600" y="1143000"/>
            <a:ext cx="2336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E8736-B89C-814A-913C-8788B1172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5238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0600" y="1143000"/>
            <a:ext cx="2336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fusion matrices and performance metrics for mouse neutrophils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9E8736-B89C-814A-913C-8788B1172B9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3839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0600" y="1143000"/>
            <a:ext cx="2336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p feature box plots mouse neutrophi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9E8736-B89C-814A-913C-8788B1172B9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4166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0600" y="1143000"/>
            <a:ext cx="2336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dividual channels for fig. 5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d4 B4 12h 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d4 PMA E4 12h 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 B5 12h 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 PMA E5 12h 1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9E8736-B89C-814A-913C-8788B1172B9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1515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0600" y="1143000"/>
            <a:ext cx="2336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ositional plots 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9E8736-B89C-814A-913C-8788B1172B9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23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944130"/>
            <a:ext cx="7649607" cy="4135743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6239364"/>
            <a:ext cx="6749654" cy="2868071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672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791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632461"/>
            <a:ext cx="1940525" cy="1006712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632461"/>
            <a:ext cx="5709082" cy="1006712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403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057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961570"/>
            <a:ext cx="7762102" cy="4941443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7949760"/>
            <a:ext cx="7762102" cy="2598588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>
                    <a:tint val="82000"/>
                  </a:schemeClr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82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82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957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162304"/>
            <a:ext cx="3824804" cy="7537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162304"/>
            <a:ext cx="3824804" cy="7537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810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632464"/>
            <a:ext cx="7762102" cy="229610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912070"/>
            <a:ext cx="3807226" cy="142716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4339231"/>
            <a:ext cx="3807226" cy="6382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912070"/>
            <a:ext cx="3825976" cy="142716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4339231"/>
            <a:ext cx="3825976" cy="6382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745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206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429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91951"/>
            <a:ext cx="2902585" cy="2771828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710397"/>
            <a:ext cx="4556016" cy="8441976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563779"/>
            <a:ext cx="2902585" cy="6602341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932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91951"/>
            <a:ext cx="2902585" cy="2771828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710397"/>
            <a:ext cx="4556016" cy="8441976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563779"/>
            <a:ext cx="2902585" cy="6602341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816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632464"/>
            <a:ext cx="7762102" cy="2296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162304"/>
            <a:ext cx="7762102" cy="7537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1010319"/>
            <a:ext cx="2024896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E3FE60-1C24-9D44-8071-0E3180D9A3A9}" type="datetimeFigureOut">
              <a:rPr lang="en-US" smtClean="0"/>
              <a:t>2/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1010319"/>
            <a:ext cx="3037344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1010319"/>
            <a:ext cx="2024896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5DC27F-6A3E-AE47-8780-2D93BE133C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364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26.png"/><Relationship Id="rId18" Type="http://schemas.microsoft.com/office/2007/relationships/hdphoto" Target="../media/hdphoto6.wdp"/><Relationship Id="rId26" Type="http://schemas.openxmlformats.org/officeDocument/2006/relationships/image" Target="../media/image34.jpeg"/><Relationship Id="rId3" Type="http://schemas.openxmlformats.org/officeDocument/2006/relationships/image" Target="../media/image19.png"/><Relationship Id="rId21" Type="http://schemas.openxmlformats.org/officeDocument/2006/relationships/image" Target="../media/image30.png"/><Relationship Id="rId7" Type="http://schemas.openxmlformats.org/officeDocument/2006/relationships/image" Target="../media/image23.png"/><Relationship Id="rId12" Type="http://schemas.microsoft.com/office/2007/relationships/hdphoto" Target="../media/hdphoto3.wdp"/><Relationship Id="rId17" Type="http://schemas.openxmlformats.org/officeDocument/2006/relationships/image" Target="../media/image28.png"/><Relationship Id="rId25" Type="http://schemas.openxmlformats.org/officeDocument/2006/relationships/image" Target="../media/image33.jpeg"/><Relationship Id="rId2" Type="http://schemas.openxmlformats.org/officeDocument/2006/relationships/notesSlide" Target="../notesSlides/notesSlide3.xml"/><Relationship Id="rId16" Type="http://schemas.microsoft.com/office/2007/relationships/hdphoto" Target="../media/hdphoto5.wdp"/><Relationship Id="rId20" Type="http://schemas.microsoft.com/office/2007/relationships/hdphoto" Target="../media/hdphoto7.wdp"/><Relationship Id="rId29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image" Target="../media/image25.png"/><Relationship Id="rId24" Type="http://schemas.openxmlformats.org/officeDocument/2006/relationships/image" Target="../media/image32.jpeg"/><Relationship Id="rId5" Type="http://schemas.openxmlformats.org/officeDocument/2006/relationships/image" Target="../media/image21.png"/><Relationship Id="rId15" Type="http://schemas.openxmlformats.org/officeDocument/2006/relationships/image" Target="../media/image27.png"/><Relationship Id="rId23" Type="http://schemas.openxmlformats.org/officeDocument/2006/relationships/image" Target="../media/image31.jpeg"/><Relationship Id="rId28" Type="http://schemas.openxmlformats.org/officeDocument/2006/relationships/image" Target="../media/image36.png"/><Relationship Id="rId10" Type="http://schemas.microsoft.com/office/2007/relationships/hdphoto" Target="../media/hdphoto2.wdp"/><Relationship Id="rId19" Type="http://schemas.openxmlformats.org/officeDocument/2006/relationships/image" Target="../media/image29.png"/><Relationship Id="rId31" Type="http://schemas.openxmlformats.org/officeDocument/2006/relationships/image" Target="../media/image39.png"/><Relationship Id="rId4" Type="http://schemas.openxmlformats.org/officeDocument/2006/relationships/image" Target="../media/image20.png"/><Relationship Id="rId9" Type="http://schemas.openxmlformats.org/officeDocument/2006/relationships/image" Target="../media/image24.png"/><Relationship Id="rId14" Type="http://schemas.microsoft.com/office/2007/relationships/hdphoto" Target="../media/hdphoto4.wdp"/><Relationship Id="rId22" Type="http://schemas.microsoft.com/office/2007/relationships/hdphoto" Target="../media/hdphoto8.wdp"/><Relationship Id="rId27" Type="http://schemas.openxmlformats.org/officeDocument/2006/relationships/image" Target="../media/image35.png"/><Relationship Id="rId30" Type="http://schemas.openxmlformats.org/officeDocument/2006/relationships/image" Target="../media/image3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sv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3.svg"/><Relationship Id="rId4" Type="http://schemas.openxmlformats.org/officeDocument/2006/relationships/image" Target="../media/image4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number of numbers&#10;&#10;AI-generated content may be incorrect.">
            <a:extLst>
              <a:ext uri="{FF2B5EF4-FFF2-40B4-BE49-F238E27FC236}">
                <a16:creationId xmlns:a16="http://schemas.microsoft.com/office/drawing/2014/main" id="{37348A10-BB87-1DBA-C35C-9D41C0D64D6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484"/>
          <a:stretch>
            <a:fillRect/>
          </a:stretch>
        </p:blipFill>
        <p:spPr>
          <a:xfrm>
            <a:off x="5128003" y="562445"/>
            <a:ext cx="2661055" cy="2111591"/>
          </a:xfrm>
          <a:prstGeom prst="rect">
            <a:avLst/>
          </a:prstGeom>
        </p:spPr>
      </p:pic>
      <p:pic>
        <p:nvPicPr>
          <p:cNvPr id="9" name="Picture 8" descr="A diagram of a number of numbers&#10;&#10;AI-generated content may be incorrect.">
            <a:extLst>
              <a:ext uri="{FF2B5EF4-FFF2-40B4-BE49-F238E27FC236}">
                <a16:creationId xmlns:a16="http://schemas.microsoft.com/office/drawing/2014/main" id="{92C269AA-2AD1-058A-87E6-8F71FED7527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484"/>
          <a:stretch>
            <a:fillRect/>
          </a:stretch>
        </p:blipFill>
        <p:spPr>
          <a:xfrm>
            <a:off x="5128002" y="5388925"/>
            <a:ext cx="2661056" cy="2111591"/>
          </a:xfrm>
          <a:prstGeom prst="rect">
            <a:avLst/>
          </a:prstGeom>
        </p:spPr>
      </p:pic>
      <p:pic>
        <p:nvPicPr>
          <p:cNvPr id="11" name="Picture 10" descr="A screenshot of a graph&#10;&#10;AI-generated content may be incorrect.">
            <a:extLst>
              <a:ext uri="{FF2B5EF4-FFF2-40B4-BE49-F238E27FC236}">
                <a16:creationId xmlns:a16="http://schemas.microsoft.com/office/drawing/2014/main" id="{F9FF1690-B8E4-CD19-9F0A-7824F4B4AE4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2481"/>
          <a:stretch>
            <a:fillRect/>
          </a:stretch>
        </p:blipFill>
        <p:spPr>
          <a:xfrm>
            <a:off x="1247849" y="5508357"/>
            <a:ext cx="3062504" cy="2239893"/>
          </a:xfrm>
          <a:prstGeom prst="rect">
            <a:avLst/>
          </a:prstGeom>
        </p:spPr>
      </p:pic>
      <p:pic>
        <p:nvPicPr>
          <p:cNvPr id="13" name="Picture 12" descr="A graph of a number of data&#10;&#10;AI-generated content may be incorrect.">
            <a:extLst>
              <a:ext uri="{FF2B5EF4-FFF2-40B4-BE49-F238E27FC236}">
                <a16:creationId xmlns:a16="http://schemas.microsoft.com/office/drawing/2014/main" id="{5A8A150C-3EE4-7B9B-1E15-5B4C8DE946E3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5484"/>
          <a:stretch>
            <a:fillRect/>
          </a:stretch>
        </p:blipFill>
        <p:spPr>
          <a:xfrm>
            <a:off x="5124767" y="7784725"/>
            <a:ext cx="2661056" cy="2111591"/>
          </a:xfrm>
          <a:prstGeom prst="rect">
            <a:avLst/>
          </a:prstGeom>
        </p:spPr>
      </p:pic>
      <p:pic>
        <p:nvPicPr>
          <p:cNvPr id="15" name="Picture 14" descr="A screenshot of a graph&#10;&#10;AI-generated content may be incorrect.">
            <a:extLst>
              <a:ext uri="{FF2B5EF4-FFF2-40B4-BE49-F238E27FC236}">
                <a16:creationId xmlns:a16="http://schemas.microsoft.com/office/drawing/2014/main" id="{6B082552-2B8E-4D02-8395-440E13C30508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b="2355"/>
          <a:stretch>
            <a:fillRect/>
          </a:stretch>
        </p:blipFill>
        <p:spPr>
          <a:xfrm>
            <a:off x="1247849" y="7927201"/>
            <a:ext cx="3058533" cy="2239893"/>
          </a:xfrm>
          <a:prstGeom prst="rect">
            <a:avLst/>
          </a:prstGeom>
        </p:spPr>
      </p:pic>
      <p:pic>
        <p:nvPicPr>
          <p:cNvPr id="3" name="Picture 2" descr="A screenshot of a graph&#10;&#10;AI-generated content may be incorrect.">
            <a:extLst>
              <a:ext uri="{FF2B5EF4-FFF2-40B4-BE49-F238E27FC236}">
                <a16:creationId xmlns:a16="http://schemas.microsoft.com/office/drawing/2014/main" id="{28F2CB3F-884D-A188-CF71-96765E3CF9B3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b="3492"/>
          <a:stretch>
            <a:fillRect/>
          </a:stretch>
        </p:blipFill>
        <p:spPr>
          <a:xfrm>
            <a:off x="1247848" y="709586"/>
            <a:ext cx="3058534" cy="2213808"/>
          </a:xfrm>
          <a:prstGeom prst="rect">
            <a:avLst/>
          </a:prstGeom>
        </p:spPr>
      </p:pic>
      <p:pic>
        <p:nvPicPr>
          <p:cNvPr id="6" name="Picture 5" descr="A chart of a number of numbers&#10;&#10;AI-generated content may be incorrect.">
            <a:extLst>
              <a:ext uri="{FF2B5EF4-FFF2-40B4-BE49-F238E27FC236}">
                <a16:creationId xmlns:a16="http://schemas.microsoft.com/office/drawing/2014/main" id="{134873F8-C883-4BE2-B53F-B19ABE9C4B56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5484"/>
          <a:stretch>
            <a:fillRect/>
          </a:stretch>
        </p:blipFill>
        <p:spPr>
          <a:xfrm>
            <a:off x="5128002" y="2969059"/>
            <a:ext cx="2661055" cy="2111591"/>
          </a:xfrm>
          <a:prstGeom prst="rect">
            <a:avLst/>
          </a:prstGeom>
        </p:spPr>
      </p:pic>
      <p:pic>
        <p:nvPicPr>
          <p:cNvPr id="10" name="Picture 9" descr="A screenshot of a graph&#10;&#10;AI-generated content may be incorrect.">
            <a:extLst>
              <a:ext uri="{FF2B5EF4-FFF2-40B4-BE49-F238E27FC236}">
                <a16:creationId xmlns:a16="http://schemas.microsoft.com/office/drawing/2014/main" id="{E4496929-2237-646C-BA8E-14A7F879814E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b="3492"/>
          <a:stretch>
            <a:fillRect/>
          </a:stretch>
        </p:blipFill>
        <p:spPr>
          <a:xfrm>
            <a:off x="1247849" y="3102345"/>
            <a:ext cx="3058533" cy="221380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16EA4C3-9B3C-686C-05D7-EEF2E0B1A22C}"/>
              </a:ext>
            </a:extLst>
          </p:cNvPr>
          <p:cNvSpPr txBox="1"/>
          <p:nvPr/>
        </p:nvSpPr>
        <p:spPr>
          <a:xfrm>
            <a:off x="1564080" y="568539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F52450D-A471-B082-9DE2-8A91AD66071F}"/>
              </a:ext>
            </a:extLst>
          </p:cNvPr>
          <p:cNvSpPr txBox="1"/>
          <p:nvPr/>
        </p:nvSpPr>
        <p:spPr>
          <a:xfrm>
            <a:off x="1565156" y="295695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6B6172-DA90-EAE7-70B6-49583954E0EF}"/>
              </a:ext>
            </a:extLst>
          </p:cNvPr>
          <p:cNvSpPr txBox="1"/>
          <p:nvPr/>
        </p:nvSpPr>
        <p:spPr>
          <a:xfrm>
            <a:off x="1566484" y="5382016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363715-E9AC-2BB0-B8CA-E042C8438F21}"/>
              </a:ext>
            </a:extLst>
          </p:cNvPr>
          <p:cNvSpPr txBox="1"/>
          <p:nvPr/>
        </p:nvSpPr>
        <p:spPr>
          <a:xfrm>
            <a:off x="1564080" y="7747218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37B0FBD-0DF8-073F-B90E-B19EA9C420AB}"/>
              </a:ext>
            </a:extLst>
          </p:cNvPr>
          <p:cNvSpPr txBox="1"/>
          <p:nvPr/>
        </p:nvSpPr>
        <p:spPr>
          <a:xfrm>
            <a:off x="1192668" y="10393105"/>
            <a:ext cx="68666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</a:t>
            </a:r>
            <a:r>
              <a:rPr lang="fr-CA" sz="1000" b="1" dirty="0"/>
              <a:t>12. CPA classification </a:t>
            </a:r>
            <a:r>
              <a:rPr lang="fr-CA" sz="1000" b="1" dirty="0" err="1"/>
              <a:t>accuracy</a:t>
            </a:r>
            <a:r>
              <a:rPr lang="fr-CA" sz="1000" b="1" dirty="0"/>
              <a:t> and performance for mouse </a:t>
            </a:r>
            <a:r>
              <a:rPr lang="fr-CA" sz="1000" b="1" dirty="0" err="1"/>
              <a:t>bone</a:t>
            </a:r>
            <a:r>
              <a:rPr lang="fr-CA" sz="1000" b="1" dirty="0"/>
              <a:t> </a:t>
            </a:r>
            <a:r>
              <a:rPr lang="fr-CA" sz="1000" b="1" dirty="0" err="1"/>
              <a:t>marrow-derived</a:t>
            </a:r>
            <a:r>
              <a:rPr lang="fr-CA" sz="1000" b="1" dirty="0"/>
              <a:t> </a:t>
            </a:r>
            <a:r>
              <a:rPr lang="fr-CA" sz="1000" b="1" dirty="0" err="1"/>
              <a:t>neutrophil</a:t>
            </a:r>
            <a:r>
              <a:rPr lang="fr-CA" sz="1000" b="1" dirty="0"/>
              <a:t> </a:t>
            </a:r>
            <a:r>
              <a:rPr lang="fr-CA" sz="1000" b="1" dirty="0" err="1"/>
              <a:t>experiments</a:t>
            </a:r>
            <a:r>
              <a:rPr lang="fr-CA" sz="1000" b="1" dirty="0"/>
              <a:t>. (A-E)</a:t>
            </a:r>
            <a:r>
              <a:rPr lang="fr-CA" sz="1000" dirty="0"/>
              <a:t>, Confusion matrices and </a:t>
            </a:r>
            <a:r>
              <a:rPr lang="fr-CA" sz="1000" dirty="0" err="1"/>
              <a:t>corresponding</a:t>
            </a:r>
            <a:r>
              <a:rPr lang="fr-CA" sz="1000" dirty="0"/>
              <a:t> performance </a:t>
            </a:r>
            <a:r>
              <a:rPr lang="fr-CA" sz="1000" dirty="0" err="1"/>
              <a:t>metrics</a:t>
            </a:r>
            <a:r>
              <a:rPr lang="fr-CA" sz="1000" dirty="0"/>
              <a:t> </a:t>
            </a:r>
            <a:r>
              <a:rPr lang="fr-CA" sz="1000" dirty="0" err="1"/>
              <a:t>from</a:t>
            </a:r>
            <a:r>
              <a:rPr lang="fr-CA" sz="1000" dirty="0"/>
              <a:t> CPA training </a:t>
            </a:r>
            <a:r>
              <a:rPr lang="fr-CA" sz="1000" dirty="0" err="1"/>
              <a:t>datasets</a:t>
            </a:r>
            <a:r>
              <a:rPr lang="fr-CA" sz="1000" dirty="0"/>
              <a:t> </a:t>
            </a:r>
            <a:r>
              <a:rPr lang="fr-CA" sz="1000" dirty="0" err="1"/>
              <a:t>evaluated</a:t>
            </a:r>
            <a:r>
              <a:rPr lang="fr-CA" sz="1000" dirty="0"/>
              <a:t> </a:t>
            </a:r>
            <a:r>
              <a:rPr lang="fr-CA" sz="1000" dirty="0" err="1"/>
              <a:t>using</a:t>
            </a:r>
            <a:r>
              <a:rPr lang="fr-CA" sz="1000" dirty="0"/>
              <a:t> </a:t>
            </a:r>
            <a:r>
              <a:rPr lang="fr-CA" sz="1000" dirty="0" err="1"/>
              <a:t>stratified</a:t>
            </a:r>
            <a:r>
              <a:rPr lang="fr-CA" sz="1000" dirty="0"/>
              <a:t> test k-</a:t>
            </a:r>
            <a:r>
              <a:rPr lang="fr-CA" sz="1000" dirty="0" err="1"/>
              <a:t>fold</a:t>
            </a:r>
            <a:r>
              <a:rPr lang="fr-CA" sz="1000" dirty="0"/>
              <a:t> cross-validation (k=5).  </a:t>
            </a:r>
            <a:r>
              <a:rPr lang="fr-CA" sz="1000" b="1" dirty="0"/>
              <a:t>(A)</a:t>
            </a:r>
            <a:r>
              <a:rPr lang="fr-CA" sz="1000" dirty="0"/>
              <a:t>, </a:t>
            </a:r>
            <a:r>
              <a:rPr lang="fr-CA" sz="1000" dirty="0" err="1"/>
              <a:t>Dataset</a:t>
            </a:r>
            <a:r>
              <a:rPr lang="fr-CA" sz="1000" dirty="0"/>
              <a:t> 1;</a:t>
            </a:r>
            <a:r>
              <a:rPr lang="fr-CA" sz="1000" b="1" dirty="0"/>
              <a:t> (B)</a:t>
            </a:r>
            <a:r>
              <a:rPr lang="fr-CA" sz="1000" dirty="0"/>
              <a:t>, </a:t>
            </a:r>
            <a:r>
              <a:rPr lang="fr-CA" sz="1000" dirty="0" err="1"/>
              <a:t>Dataset</a:t>
            </a:r>
            <a:r>
              <a:rPr lang="fr-CA" sz="1000" dirty="0"/>
              <a:t> 2;</a:t>
            </a:r>
            <a:r>
              <a:rPr lang="fr-CA" sz="1000" b="1" dirty="0"/>
              <a:t> (C)</a:t>
            </a:r>
            <a:r>
              <a:rPr lang="fr-CA" sz="1000" dirty="0"/>
              <a:t>, </a:t>
            </a:r>
            <a:r>
              <a:rPr lang="fr-CA" sz="1000" dirty="0" err="1"/>
              <a:t>Dataset</a:t>
            </a:r>
            <a:r>
              <a:rPr lang="fr-CA" sz="1000" dirty="0"/>
              <a:t> 3;</a:t>
            </a:r>
            <a:r>
              <a:rPr lang="fr-CA" sz="1000" b="1" dirty="0"/>
              <a:t> (D)</a:t>
            </a:r>
            <a:r>
              <a:rPr lang="fr-CA" sz="1000" dirty="0"/>
              <a:t>, </a:t>
            </a:r>
            <a:r>
              <a:rPr lang="fr-CA" sz="1000" dirty="0" err="1"/>
              <a:t>Dataset</a:t>
            </a:r>
            <a:r>
              <a:rPr lang="fr-CA" sz="1000" dirty="0"/>
              <a:t> 4.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5DA48E-6CCB-D9F0-1A56-179BC75F0553}"/>
              </a:ext>
            </a:extLst>
          </p:cNvPr>
          <p:cNvSpPr txBox="1"/>
          <p:nvPr/>
        </p:nvSpPr>
        <p:spPr>
          <a:xfrm>
            <a:off x="2697256" y="2924266"/>
            <a:ext cx="606256" cy="1692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Predicted labe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A3C853B-107C-8BC9-E075-6D8EE961CC00}"/>
              </a:ext>
            </a:extLst>
          </p:cNvPr>
          <p:cNvSpPr txBox="1"/>
          <p:nvPr/>
        </p:nvSpPr>
        <p:spPr>
          <a:xfrm>
            <a:off x="4372070" y="712517"/>
            <a:ext cx="881973" cy="1676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405000"/>
              </a:lnSpc>
            </a:pPr>
            <a:r>
              <a:rPr lang="en-US" sz="530" err="1">
                <a:latin typeface="Arial" panose="020B0604020202020204" pitchFamily="34" charset="0"/>
                <a:cs typeface="Arial" panose="020B0604020202020204" pitchFamily="34" charset="0"/>
              </a:rPr>
              <a:t>NETosis</a:t>
            </a:r>
            <a:endParaRPr lang="en-US" sz="53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Spread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Negative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Disintegrated nucleus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Dead 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94E7401-6C19-6DB7-617A-3389242325F6}"/>
              </a:ext>
            </a:extLst>
          </p:cNvPr>
          <p:cNvSpPr txBox="1"/>
          <p:nvPr/>
        </p:nvSpPr>
        <p:spPr>
          <a:xfrm>
            <a:off x="2697256" y="5325827"/>
            <a:ext cx="606256" cy="1692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Predicted labe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4489CED-6632-F0A2-8A43-3D61AD5B92B1}"/>
              </a:ext>
            </a:extLst>
          </p:cNvPr>
          <p:cNvSpPr txBox="1"/>
          <p:nvPr/>
        </p:nvSpPr>
        <p:spPr>
          <a:xfrm>
            <a:off x="2695422" y="7738809"/>
            <a:ext cx="606256" cy="1692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500">
                <a:latin typeface="Arial" panose="020B0604020202020204" pitchFamily="34" charset="0"/>
                <a:cs typeface="Arial" panose="020B0604020202020204" pitchFamily="34" charset="0"/>
              </a:rPr>
              <a:t>Predicted labe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21D7CEB-50DC-E04E-1763-2DCB58603592}"/>
              </a:ext>
            </a:extLst>
          </p:cNvPr>
          <p:cNvSpPr txBox="1"/>
          <p:nvPr/>
        </p:nvSpPr>
        <p:spPr>
          <a:xfrm>
            <a:off x="2695422" y="10086664"/>
            <a:ext cx="606256" cy="1692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Predicted labe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E76A30-71C2-5804-92C3-BA30691D37B2}"/>
              </a:ext>
            </a:extLst>
          </p:cNvPr>
          <p:cNvSpPr txBox="1"/>
          <p:nvPr/>
        </p:nvSpPr>
        <p:spPr>
          <a:xfrm>
            <a:off x="4375002" y="3112358"/>
            <a:ext cx="920445" cy="1676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405000"/>
              </a:lnSpc>
            </a:pPr>
            <a:r>
              <a:rPr lang="en-US" sz="530" dirty="0">
                <a:latin typeface="Arial" panose="020B0604020202020204" pitchFamily="34" charset="0"/>
                <a:cs typeface="Arial" panose="020B0604020202020204" pitchFamily="34" charset="0"/>
              </a:rPr>
              <a:t> Dead    </a:t>
            </a:r>
          </a:p>
          <a:p>
            <a:pPr algn="r">
              <a:lnSpc>
                <a:spcPct val="405000"/>
              </a:lnSpc>
            </a:pPr>
            <a:r>
              <a:rPr lang="en-US" sz="530" dirty="0">
                <a:latin typeface="Arial" panose="020B0604020202020204" pitchFamily="34" charset="0"/>
                <a:cs typeface="Arial" panose="020B0604020202020204" pitchFamily="34" charset="0"/>
              </a:rPr>
              <a:t> Spread    </a:t>
            </a:r>
          </a:p>
          <a:p>
            <a:pPr algn="r">
              <a:lnSpc>
                <a:spcPct val="405000"/>
              </a:lnSpc>
            </a:pPr>
            <a:r>
              <a:rPr lang="en-US" sz="530" dirty="0">
                <a:latin typeface="Arial" panose="020B0604020202020204" pitchFamily="34" charset="0"/>
                <a:cs typeface="Arial" panose="020B0604020202020204" pitchFamily="34" charset="0"/>
              </a:rPr>
              <a:t>Disintegrated nucleus    </a:t>
            </a:r>
          </a:p>
          <a:p>
            <a:pPr algn="r">
              <a:lnSpc>
                <a:spcPct val="405000"/>
              </a:lnSpc>
            </a:pPr>
            <a:r>
              <a:rPr lang="en-US" sz="530" dirty="0">
                <a:latin typeface="Arial" panose="020B0604020202020204" pitchFamily="34" charset="0"/>
                <a:cs typeface="Arial" panose="020B0604020202020204" pitchFamily="34" charset="0"/>
              </a:rPr>
              <a:t>Negative    </a:t>
            </a:r>
          </a:p>
          <a:p>
            <a:pPr algn="r">
              <a:lnSpc>
                <a:spcPct val="405000"/>
              </a:lnSpc>
            </a:pPr>
            <a:r>
              <a:rPr lang="en-US" sz="530" dirty="0" err="1">
                <a:latin typeface="Arial" panose="020B0604020202020204" pitchFamily="34" charset="0"/>
                <a:cs typeface="Arial" panose="020B0604020202020204" pitchFamily="34" charset="0"/>
              </a:rPr>
              <a:t>NETosis</a:t>
            </a:r>
            <a:r>
              <a:rPr lang="en-US" sz="53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68BED47-FE40-F84B-7228-E2CDE739227A}"/>
              </a:ext>
            </a:extLst>
          </p:cNvPr>
          <p:cNvSpPr txBox="1"/>
          <p:nvPr/>
        </p:nvSpPr>
        <p:spPr>
          <a:xfrm>
            <a:off x="4405774" y="5527472"/>
            <a:ext cx="881973" cy="1676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Spread  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Disintegrated nucleus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Negative   </a:t>
            </a:r>
          </a:p>
          <a:p>
            <a:pPr algn="r">
              <a:lnSpc>
                <a:spcPct val="405000"/>
              </a:lnSpc>
            </a:pPr>
            <a:r>
              <a:rPr lang="en-US" sz="530" err="1">
                <a:latin typeface="Arial" panose="020B0604020202020204" pitchFamily="34" charset="0"/>
                <a:cs typeface="Arial" panose="020B0604020202020204" pitchFamily="34" charset="0"/>
              </a:rPr>
              <a:t>NETosis</a:t>
            </a: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Dead   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47B0C79-34A4-072F-39EC-5793B0ECCD8F}"/>
              </a:ext>
            </a:extLst>
          </p:cNvPr>
          <p:cNvSpPr txBox="1"/>
          <p:nvPr/>
        </p:nvSpPr>
        <p:spPr>
          <a:xfrm>
            <a:off x="4402330" y="7927201"/>
            <a:ext cx="901209" cy="1676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Negative   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Dead   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Spread     </a:t>
            </a:r>
          </a:p>
          <a:p>
            <a:pPr algn="r">
              <a:lnSpc>
                <a:spcPct val="405000"/>
              </a:lnSpc>
            </a:pP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Disintegrated nucleus   </a:t>
            </a:r>
          </a:p>
          <a:p>
            <a:pPr algn="r">
              <a:lnSpc>
                <a:spcPct val="405000"/>
              </a:lnSpc>
            </a:pPr>
            <a:r>
              <a:rPr lang="en-US" sz="530" err="1">
                <a:latin typeface="Arial" panose="020B0604020202020204" pitchFamily="34" charset="0"/>
                <a:cs typeface="Arial" panose="020B0604020202020204" pitchFamily="34" charset="0"/>
              </a:rPr>
              <a:t>NETosis</a:t>
            </a:r>
            <a:r>
              <a:rPr lang="en-US" sz="53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EE4DAAA-6463-DC0D-BE7E-99EE0A6AAAD0}"/>
              </a:ext>
            </a:extLst>
          </p:cNvPr>
          <p:cNvSpPr txBox="1"/>
          <p:nvPr/>
        </p:nvSpPr>
        <p:spPr>
          <a:xfrm>
            <a:off x="474202" y="1655851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ataset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E43C78-95BD-955A-A449-353644A1C5B9}"/>
              </a:ext>
            </a:extLst>
          </p:cNvPr>
          <p:cNvSpPr txBox="1"/>
          <p:nvPr/>
        </p:nvSpPr>
        <p:spPr>
          <a:xfrm>
            <a:off x="474202" y="4053163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ataset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CE8759-E0F4-CB83-3EB1-D51A5FC38AFF}"/>
              </a:ext>
            </a:extLst>
          </p:cNvPr>
          <p:cNvSpPr txBox="1"/>
          <p:nvPr/>
        </p:nvSpPr>
        <p:spPr>
          <a:xfrm>
            <a:off x="474202" y="6460045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ataset 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1C04B6B-791E-D5DF-C35E-1ECB5C161FCF}"/>
              </a:ext>
            </a:extLst>
          </p:cNvPr>
          <p:cNvSpPr txBox="1"/>
          <p:nvPr/>
        </p:nvSpPr>
        <p:spPr>
          <a:xfrm>
            <a:off x="529382" y="8855845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ataset 4</a:t>
            </a:r>
          </a:p>
        </p:txBody>
      </p:sp>
    </p:spTree>
    <p:extLst>
      <p:ext uri="{BB962C8B-B14F-4D97-AF65-F5344CB8AC3E}">
        <p14:creationId xmlns:p14="http://schemas.microsoft.com/office/powerpoint/2010/main" val="42624638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A74E1D-2C2B-1A56-9968-0F2636681345}"/>
              </a:ext>
            </a:extLst>
          </p:cNvPr>
          <p:cNvSpPr txBox="1"/>
          <p:nvPr/>
        </p:nvSpPr>
        <p:spPr>
          <a:xfrm>
            <a:off x="795709" y="10456359"/>
            <a:ext cx="756225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000" b="1" dirty="0" err="1"/>
              <a:t>Supplementary</a:t>
            </a:r>
            <a:r>
              <a:rPr lang="fr-CA" sz="1000" b="1" dirty="0"/>
              <a:t> Figure 13. Top 10 classification </a:t>
            </a:r>
            <a:r>
              <a:rPr lang="fr-CA" sz="1000" b="1" dirty="0" err="1"/>
              <a:t>features</a:t>
            </a:r>
            <a:r>
              <a:rPr lang="fr-CA" sz="1000" b="1" dirty="0"/>
              <a:t>  for mouse </a:t>
            </a:r>
            <a:r>
              <a:rPr lang="fr-CA" sz="1000" b="1" dirty="0" err="1"/>
              <a:t>bone</a:t>
            </a:r>
            <a:r>
              <a:rPr lang="fr-CA" sz="1000" b="1" dirty="0"/>
              <a:t> </a:t>
            </a:r>
            <a:r>
              <a:rPr lang="fr-CA" sz="1000" b="1" dirty="0" err="1"/>
              <a:t>marrow-derived</a:t>
            </a:r>
            <a:r>
              <a:rPr lang="fr-CA" sz="1000" b="1" dirty="0"/>
              <a:t> </a:t>
            </a:r>
            <a:r>
              <a:rPr lang="fr-CA" sz="1000" b="1" dirty="0" err="1"/>
              <a:t>neutrophil</a:t>
            </a:r>
            <a:r>
              <a:rPr lang="fr-CA" sz="1000" b="1" dirty="0"/>
              <a:t> </a:t>
            </a:r>
            <a:r>
              <a:rPr lang="fr-CA" sz="1000" b="1" dirty="0" err="1"/>
              <a:t>sorting</a:t>
            </a:r>
            <a:r>
              <a:rPr lang="fr-CA" sz="1000" b="1" dirty="0"/>
              <a:t>. </a:t>
            </a:r>
            <a:r>
              <a:rPr lang="en-CA" sz="1000" dirty="0"/>
              <a:t>Boxplots showing the distribution of each feature across classified cell types (n = 4 experiments, N = 2,183 cells). Mann-Whitney test and Holm-Bonferroni correction performed</a:t>
            </a:r>
            <a:r>
              <a:rPr lang="fr-CA" sz="1000" dirty="0"/>
              <a:t> </a:t>
            </a:r>
            <a:r>
              <a:rPr lang="en-US" sz="1000" dirty="0"/>
              <a:t>*P&lt;0.05, **P&lt;0.01, ***P&lt;0.001, </a:t>
            </a:r>
            <a:r>
              <a:rPr lang="fr-CA" sz="1000" dirty="0"/>
              <a:t>****P&lt;0.0001</a:t>
            </a:r>
            <a:r>
              <a:rPr lang="en-CA" sz="1000" dirty="0"/>
              <a:t>.</a:t>
            </a:r>
            <a:endParaRPr lang="en-US" sz="1000" dirty="0"/>
          </a:p>
        </p:txBody>
      </p:sp>
      <p:pic>
        <p:nvPicPr>
          <p:cNvPr id="4" name="Picture 3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FA649EC4-127C-4C41-5406-C04374697E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54082" y="7978966"/>
            <a:ext cx="2079263" cy="2409563"/>
          </a:xfrm>
          <a:prstGeom prst="rect">
            <a:avLst/>
          </a:prstGeom>
        </p:spPr>
      </p:pic>
      <p:pic>
        <p:nvPicPr>
          <p:cNvPr id="8" name="Picture 7" descr="A graph of a number of individuals&#10;&#10;Description automatically generated with medium confidence">
            <a:extLst>
              <a:ext uri="{FF2B5EF4-FFF2-40B4-BE49-F238E27FC236}">
                <a16:creationId xmlns:a16="http://schemas.microsoft.com/office/drawing/2014/main" id="{C21E65B7-1B61-0163-9926-8791F223EC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61814" y="7978966"/>
            <a:ext cx="2041360" cy="2409563"/>
          </a:xfrm>
          <a:prstGeom prst="rect">
            <a:avLst/>
          </a:prstGeom>
        </p:spPr>
      </p:pic>
      <p:pic>
        <p:nvPicPr>
          <p:cNvPr id="12" name="Picture 11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8C97CBF5-C535-1038-E33C-6C32F9C1C7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9545" y="7978967"/>
            <a:ext cx="2041360" cy="2409563"/>
          </a:xfrm>
          <a:prstGeom prst="rect">
            <a:avLst/>
          </a:prstGeom>
        </p:spPr>
      </p:pic>
      <p:pic>
        <p:nvPicPr>
          <p:cNvPr id="16" name="Picture 15" descr="A diagram of a graph&#10;&#10;Description automatically generated">
            <a:extLst>
              <a:ext uri="{FF2B5EF4-FFF2-40B4-BE49-F238E27FC236}">
                <a16:creationId xmlns:a16="http://schemas.microsoft.com/office/drawing/2014/main" id="{F964B283-1F08-4353-3B84-FD197CDE3A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06823" y="5511660"/>
            <a:ext cx="2127997" cy="2409563"/>
          </a:xfrm>
          <a:prstGeom prst="rect">
            <a:avLst/>
          </a:prstGeom>
        </p:spPr>
      </p:pic>
      <p:pic>
        <p:nvPicPr>
          <p:cNvPr id="20" name="Picture 19" descr="A diagram of a diagram&#10;&#10;Description automatically generated with medium confidence">
            <a:extLst>
              <a:ext uri="{FF2B5EF4-FFF2-40B4-BE49-F238E27FC236}">
                <a16:creationId xmlns:a16="http://schemas.microsoft.com/office/drawing/2014/main" id="{D3113480-826A-6B37-A3D5-D4BADAC9C58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71044" y="5513003"/>
            <a:ext cx="2019700" cy="2409562"/>
          </a:xfrm>
          <a:prstGeom prst="rect">
            <a:avLst/>
          </a:prstGeom>
        </p:spPr>
      </p:pic>
      <p:pic>
        <p:nvPicPr>
          <p:cNvPr id="24" name="Picture 23" descr="A diagram of a graph&#10;&#10;Description automatically generated">
            <a:extLst>
              <a:ext uri="{FF2B5EF4-FFF2-40B4-BE49-F238E27FC236}">
                <a16:creationId xmlns:a16="http://schemas.microsoft.com/office/drawing/2014/main" id="{E6FB2353-80A2-7FF1-7438-D5F9ACD483D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36805" y="3070013"/>
            <a:ext cx="2079263" cy="2409563"/>
          </a:xfrm>
          <a:prstGeom prst="rect">
            <a:avLst/>
          </a:prstGeom>
        </p:spPr>
      </p:pic>
      <p:pic>
        <p:nvPicPr>
          <p:cNvPr id="26" name="Picture 25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EFA59DBC-B841-D319-0A9A-F6F96386BA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95709" y="5511661"/>
            <a:ext cx="2127997" cy="2409563"/>
          </a:xfrm>
          <a:prstGeom prst="rect">
            <a:avLst/>
          </a:prstGeom>
        </p:spPr>
      </p:pic>
      <p:pic>
        <p:nvPicPr>
          <p:cNvPr id="28" name="Picture 27" descr="A diagram of a graph&#10;&#10;Description automatically generated">
            <a:extLst>
              <a:ext uri="{FF2B5EF4-FFF2-40B4-BE49-F238E27FC236}">
                <a16:creationId xmlns:a16="http://schemas.microsoft.com/office/drawing/2014/main" id="{70F62057-0767-9ECE-57C6-DDD216C25ED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64834" y="3053971"/>
            <a:ext cx="2052190" cy="2409563"/>
          </a:xfrm>
          <a:prstGeom prst="rect">
            <a:avLst/>
          </a:prstGeom>
        </p:spPr>
      </p:pic>
      <p:pic>
        <p:nvPicPr>
          <p:cNvPr id="30" name="Picture 29" descr="A diagram of a graph&#10;&#10;Description automatically generated">
            <a:extLst>
              <a:ext uri="{FF2B5EF4-FFF2-40B4-BE49-F238E27FC236}">
                <a16:creationId xmlns:a16="http://schemas.microsoft.com/office/drawing/2014/main" id="{8D55EAAF-D5E5-7EA1-9D7F-1AE87862298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95273" y="669656"/>
            <a:ext cx="2127997" cy="2409563"/>
          </a:xfrm>
          <a:prstGeom prst="rect">
            <a:avLst/>
          </a:prstGeom>
        </p:spPr>
      </p:pic>
      <p:pic>
        <p:nvPicPr>
          <p:cNvPr id="32" name="Picture 31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247DD772-9CF3-F034-673B-D1FD0E7D154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107260" y="668752"/>
            <a:ext cx="2100922" cy="2409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7179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ey surface with small dots&#10;&#10;Description automatically generated">
            <a:extLst>
              <a:ext uri="{FF2B5EF4-FFF2-40B4-BE49-F238E27FC236}">
                <a16:creationId xmlns:a16="http://schemas.microsoft.com/office/drawing/2014/main" id="{747454A2-8B81-3E2C-5664-C27C9F6F82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6622" y="2034950"/>
            <a:ext cx="1760905" cy="1300669"/>
          </a:xfrm>
          <a:prstGeom prst="rect">
            <a:avLst/>
          </a:prstGeom>
        </p:spPr>
      </p:pic>
      <p:pic>
        <p:nvPicPr>
          <p:cNvPr id="8" name="Picture 7" descr="A grey surface with small dots&#10;&#10;Description automatically generated">
            <a:extLst>
              <a:ext uri="{FF2B5EF4-FFF2-40B4-BE49-F238E27FC236}">
                <a16:creationId xmlns:a16="http://schemas.microsoft.com/office/drawing/2014/main" id="{B3DDCC52-C14D-2B9F-9DCE-0467DCB1F4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59650" y="2034950"/>
            <a:ext cx="1760906" cy="1300669"/>
          </a:xfrm>
          <a:prstGeom prst="rect">
            <a:avLst/>
          </a:prstGeom>
        </p:spPr>
      </p:pic>
      <p:pic>
        <p:nvPicPr>
          <p:cNvPr id="10" name="Picture 9" descr="A grey background with small dots&#10;&#10;Description automatically generated">
            <a:extLst>
              <a:ext uri="{FF2B5EF4-FFF2-40B4-BE49-F238E27FC236}">
                <a16:creationId xmlns:a16="http://schemas.microsoft.com/office/drawing/2014/main" id="{9D8BC022-53F9-7CD4-F4F9-1EB6AE1A88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18818" y="2039305"/>
            <a:ext cx="1760905" cy="1300669"/>
          </a:xfrm>
          <a:prstGeom prst="rect">
            <a:avLst/>
          </a:prstGeom>
        </p:spPr>
      </p:pic>
      <p:pic>
        <p:nvPicPr>
          <p:cNvPr id="12" name="Picture 11" descr="A grey surface with small dots&#10;&#10;Description automatically generated">
            <a:extLst>
              <a:ext uri="{FF2B5EF4-FFF2-40B4-BE49-F238E27FC236}">
                <a16:creationId xmlns:a16="http://schemas.microsoft.com/office/drawing/2014/main" id="{EE965A47-4AA0-B205-B88E-6E4ED41AA4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97165" y="2039305"/>
            <a:ext cx="1760906" cy="1300669"/>
          </a:xfrm>
          <a:prstGeom prst="rect">
            <a:avLst/>
          </a:prstGeom>
        </p:spPr>
      </p:pic>
      <p:pic>
        <p:nvPicPr>
          <p:cNvPr id="14" name="Picture 13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479E63FF-DBF4-F36C-3EA4-3126AB147D15}"/>
              </a:ext>
            </a:extLst>
          </p:cNvPr>
          <p:cNvPicPr>
            <a:picLocks noChangeAspect="1"/>
          </p:cNvPicPr>
          <p:nvPr/>
        </p:nvPicPr>
        <p:blipFill>
          <a:blip r:embed="rId7">
            <a:duotone>
              <a:prstClr val="black"/>
              <a:srgbClr val="FF0000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00000"/>
                    </a14:imgEffect>
                    <a14:imgEffect>
                      <a14:colorTemperature colorTemp="11200"/>
                    </a14:imgEffect>
                    <a14:imgEffect>
                      <a14:saturation sat="400000"/>
                    </a14:imgEffect>
                    <a14:imgEffect>
                      <a14:brightnessContrast bright="85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6620" y="4673424"/>
            <a:ext cx="1760906" cy="1300669"/>
          </a:xfrm>
          <a:prstGeom prst="rect">
            <a:avLst/>
          </a:prstGeom>
        </p:spPr>
      </p:pic>
      <p:pic>
        <p:nvPicPr>
          <p:cNvPr id="16" name="Picture 15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3410CB38-A6C6-0C5C-7D77-EBB74BAABA2B}"/>
              </a:ext>
            </a:extLst>
          </p:cNvPr>
          <p:cNvPicPr>
            <a:picLocks noChangeAspect="1"/>
          </p:cNvPicPr>
          <p:nvPr/>
        </p:nvPicPr>
        <p:blipFill>
          <a:blip r:embed="rId9">
            <a:duotone>
              <a:prstClr val="black"/>
              <a:srgbClr val="FF0000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100000"/>
                    </a14:imgEffect>
                    <a14:imgEffect>
                      <a14:colorTemperature colorTemp="11200"/>
                    </a14:imgEffect>
                    <a14:imgEffect>
                      <a14:saturation sat="400000"/>
                    </a14:imgEffect>
                    <a14:imgEffect>
                      <a14:brightnessContrast bright="85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16236" y="4675857"/>
            <a:ext cx="1760906" cy="1300669"/>
          </a:xfrm>
          <a:prstGeom prst="rect">
            <a:avLst/>
          </a:prstGeom>
        </p:spPr>
      </p:pic>
      <p:pic>
        <p:nvPicPr>
          <p:cNvPr id="18" name="Picture 17" descr="A black background with a black square&#10;&#10;Description automatically generated">
            <a:extLst>
              <a:ext uri="{FF2B5EF4-FFF2-40B4-BE49-F238E27FC236}">
                <a16:creationId xmlns:a16="http://schemas.microsoft.com/office/drawing/2014/main" id="{26090C92-A80A-6847-B154-BB2FCB4E8AB3}"/>
              </a:ext>
            </a:extLst>
          </p:cNvPr>
          <p:cNvPicPr>
            <a:picLocks noChangeAspect="1"/>
          </p:cNvPicPr>
          <p:nvPr/>
        </p:nvPicPr>
        <p:blipFill>
          <a:blip r:embed="rId11">
            <a:duotone>
              <a:prstClr val="black"/>
              <a:srgbClr val="FF0000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100000"/>
                    </a14:imgEffect>
                    <a14:imgEffect>
                      <a14:colorTemperature colorTemp="11200"/>
                    </a14:imgEffect>
                    <a14:imgEffect>
                      <a14:saturation sat="400000"/>
                    </a14:imgEffect>
                    <a14:imgEffect>
                      <a14:brightnessContrast bright="85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59650" y="4674263"/>
            <a:ext cx="1760906" cy="1300669"/>
          </a:xfrm>
          <a:prstGeom prst="rect">
            <a:avLst/>
          </a:prstGeom>
        </p:spPr>
      </p:pic>
      <p:pic>
        <p:nvPicPr>
          <p:cNvPr id="20" name="Picture 19" descr="A black background with white spots&#10;&#10;Description automatically generated">
            <a:extLst>
              <a:ext uri="{FF2B5EF4-FFF2-40B4-BE49-F238E27FC236}">
                <a16:creationId xmlns:a16="http://schemas.microsoft.com/office/drawing/2014/main" id="{4253EE77-173F-01DA-9FDC-754B8B47E39E}"/>
              </a:ext>
            </a:extLst>
          </p:cNvPr>
          <p:cNvPicPr>
            <a:picLocks noChangeAspect="1"/>
          </p:cNvPicPr>
          <p:nvPr/>
        </p:nvPicPr>
        <p:blipFill>
          <a:blip r:embed="rId13">
            <a:duotone>
              <a:prstClr val="black"/>
              <a:srgbClr val="FF0000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100000"/>
                    </a14:imgEffect>
                    <a14:imgEffect>
                      <a14:colorTemperature colorTemp="11200"/>
                    </a14:imgEffect>
                    <a14:imgEffect>
                      <a14:saturation sat="400000"/>
                    </a14:imgEffect>
                    <a14:imgEffect>
                      <a14:brightnessContrast bright="85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93758" y="4677274"/>
            <a:ext cx="1757543" cy="1298185"/>
          </a:xfrm>
          <a:prstGeom prst="rect">
            <a:avLst/>
          </a:prstGeom>
        </p:spPr>
      </p:pic>
      <p:pic>
        <p:nvPicPr>
          <p:cNvPr id="22" name="Picture 21" descr="A black background with white dots&#10;&#10;Description automatically generated">
            <a:extLst>
              <a:ext uri="{FF2B5EF4-FFF2-40B4-BE49-F238E27FC236}">
                <a16:creationId xmlns:a16="http://schemas.microsoft.com/office/drawing/2014/main" id="{FC76CD30-7000-F94F-EB95-27BB15224243}"/>
              </a:ext>
            </a:extLst>
          </p:cNvPr>
          <p:cNvPicPr>
            <a:picLocks noChangeAspect="1"/>
          </p:cNvPicPr>
          <p:nvPr/>
        </p:nvPicPr>
        <p:blipFill>
          <a:blip r:embed="rId15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6620" y="3360777"/>
            <a:ext cx="1760907" cy="1300670"/>
          </a:xfrm>
          <a:prstGeom prst="rect">
            <a:avLst/>
          </a:prstGeom>
        </p:spPr>
      </p:pic>
      <p:pic>
        <p:nvPicPr>
          <p:cNvPr id="24" name="Picture 23" descr="A black background with white dots&#10;&#10;Description automatically generated">
            <a:extLst>
              <a:ext uri="{FF2B5EF4-FFF2-40B4-BE49-F238E27FC236}">
                <a16:creationId xmlns:a16="http://schemas.microsoft.com/office/drawing/2014/main" id="{508202CD-5718-FD09-F617-0C23547CB212}"/>
              </a:ext>
            </a:extLst>
          </p:cNvPr>
          <p:cNvPicPr>
            <a:picLocks noChangeAspect="1"/>
          </p:cNvPicPr>
          <p:nvPr/>
        </p:nvPicPr>
        <p:blipFill>
          <a:blip r:embed="rId17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16235" y="3360714"/>
            <a:ext cx="1760907" cy="1300670"/>
          </a:xfrm>
          <a:prstGeom prst="rect">
            <a:avLst/>
          </a:prstGeom>
        </p:spPr>
      </p:pic>
      <p:pic>
        <p:nvPicPr>
          <p:cNvPr id="26" name="Picture 25" descr="A black background with white dots&#10;&#10;Description automatically generated">
            <a:extLst>
              <a:ext uri="{FF2B5EF4-FFF2-40B4-BE49-F238E27FC236}">
                <a16:creationId xmlns:a16="http://schemas.microsoft.com/office/drawing/2014/main" id="{8EC9F490-84E2-0868-7A27-1D63605EC0FC}"/>
              </a:ext>
            </a:extLst>
          </p:cNvPr>
          <p:cNvPicPr>
            <a:picLocks noChangeAspect="1"/>
          </p:cNvPicPr>
          <p:nvPr/>
        </p:nvPicPr>
        <p:blipFill>
          <a:blip r:embed="rId19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59650" y="3360777"/>
            <a:ext cx="1760907" cy="1300670"/>
          </a:xfrm>
          <a:prstGeom prst="rect">
            <a:avLst/>
          </a:prstGeom>
        </p:spPr>
      </p:pic>
      <p:pic>
        <p:nvPicPr>
          <p:cNvPr id="28" name="Picture 27" descr="A black background with white dots&#10;&#10;Description automatically generated">
            <a:extLst>
              <a:ext uri="{FF2B5EF4-FFF2-40B4-BE49-F238E27FC236}">
                <a16:creationId xmlns:a16="http://schemas.microsoft.com/office/drawing/2014/main" id="{EF2C2483-8C09-A3FD-CEA1-854363D8A0C8}"/>
              </a:ext>
            </a:extLst>
          </p:cNvPr>
          <p:cNvPicPr>
            <a:picLocks noChangeAspect="1"/>
          </p:cNvPicPr>
          <p:nvPr/>
        </p:nvPicPr>
        <p:blipFill>
          <a:blip r:embed="rId21">
            <a:duotone>
              <a:prstClr val="black"/>
              <a:schemeClr val="accent3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95360" y="3360715"/>
            <a:ext cx="1760905" cy="1300669"/>
          </a:xfrm>
          <a:prstGeom prst="rect">
            <a:avLst/>
          </a:prstGeom>
        </p:spPr>
      </p:pic>
      <p:pic>
        <p:nvPicPr>
          <p:cNvPr id="3" name="Picture 2" descr="A close-up of a microscope&#10;&#10;AI-generated content may be incorrect.">
            <a:extLst>
              <a:ext uri="{FF2B5EF4-FFF2-40B4-BE49-F238E27FC236}">
                <a16:creationId xmlns:a16="http://schemas.microsoft.com/office/drawing/2014/main" id="{3F8CE384-A006-1822-90F6-5E9BDF009B95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576620" y="5994848"/>
            <a:ext cx="1760906" cy="1300669"/>
          </a:xfrm>
          <a:prstGeom prst="rect">
            <a:avLst/>
          </a:prstGeom>
        </p:spPr>
      </p:pic>
      <p:pic>
        <p:nvPicPr>
          <p:cNvPr id="6" name="Picture 5" descr="A close-up of a microscope&#10;&#10;AI-generated content may be incorrect.">
            <a:extLst>
              <a:ext uri="{FF2B5EF4-FFF2-40B4-BE49-F238E27FC236}">
                <a16:creationId xmlns:a16="http://schemas.microsoft.com/office/drawing/2014/main" id="{E954C5F3-8772-ABFA-B196-155C1DED744A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349377" y="5994849"/>
            <a:ext cx="1760906" cy="1300669"/>
          </a:xfrm>
          <a:prstGeom prst="rect">
            <a:avLst/>
          </a:prstGeom>
        </p:spPr>
      </p:pic>
      <p:pic>
        <p:nvPicPr>
          <p:cNvPr id="13" name="Picture 12" descr="A grey background with yellow and green dots&#10;&#10;AI-generated content may be incorrect.">
            <a:extLst>
              <a:ext uri="{FF2B5EF4-FFF2-40B4-BE49-F238E27FC236}">
                <a16:creationId xmlns:a16="http://schemas.microsoft.com/office/drawing/2014/main" id="{28CB1081-7BCD-0D30-6826-397317B9330E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016238" y="5999204"/>
            <a:ext cx="1760906" cy="1300669"/>
          </a:xfrm>
          <a:prstGeom prst="rect">
            <a:avLst/>
          </a:prstGeom>
        </p:spPr>
      </p:pic>
      <p:pic>
        <p:nvPicPr>
          <p:cNvPr id="17" name="Picture 16" descr="A close-up of a microscope&#10;&#10;AI-generated content may be incorrect.">
            <a:extLst>
              <a:ext uri="{FF2B5EF4-FFF2-40B4-BE49-F238E27FC236}">
                <a16:creationId xmlns:a16="http://schemas.microsoft.com/office/drawing/2014/main" id="{7C139EFC-C8B5-C2B7-2E5F-2B5694863C04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788992" y="5997834"/>
            <a:ext cx="1760906" cy="1300669"/>
          </a:xfrm>
          <a:prstGeom prst="rect">
            <a:avLst/>
          </a:prstGeom>
        </p:spPr>
      </p:pic>
      <p:pic>
        <p:nvPicPr>
          <p:cNvPr id="21" name="Picture 20" descr="A grey background with many small dots&#10;&#10;AI-generated content may be incorrect.">
            <a:extLst>
              <a:ext uri="{FF2B5EF4-FFF2-40B4-BE49-F238E27FC236}">
                <a16:creationId xmlns:a16="http://schemas.microsoft.com/office/drawing/2014/main" id="{B8D02BFE-5261-27DC-7B59-C085F8081D7C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574055" y="7316271"/>
            <a:ext cx="1763471" cy="1300669"/>
          </a:xfrm>
          <a:prstGeom prst="rect">
            <a:avLst/>
          </a:prstGeom>
        </p:spPr>
      </p:pic>
      <p:pic>
        <p:nvPicPr>
          <p:cNvPr id="25" name="Picture 24" descr="A grey background with many small dots&#10;&#10;AI-generated content may be incorrect.">
            <a:extLst>
              <a:ext uri="{FF2B5EF4-FFF2-40B4-BE49-F238E27FC236}">
                <a16:creationId xmlns:a16="http://schemas.microsoft.com/office/drawing/2014/main" id="{702C46E3-1DEE-4355-DC36-ECECBA1BB217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6361331" y="7316271"/>
            <a:ext cx="1757543" cy="1300669"/>
          </a:xfrm>
          <a:prstGeom prst="rect">
            <a:avLst/>
          </a:prstGeom>
        </p:spPr>
      </p:pic>
      <p:pic>
        <p:nvPicPr>
          <p:cNvPr id="29" name="Picture 28" descr="A grey background with many dots&#10;&#10;AI-generated content may be incorrect.">
            <a:extLst>
              <a:ext uri="{FF2B5EF4-FFF2-40B4-BE49-F238E27FC236}">
                <a16:creationId xmlns:a16="http://schemas.microsoft.com/office/drawing/2014/main" id="{54629C60-6940-0449-2EEE-6DDDA34E3279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016235" y="7320626"/>
            <a:ext cx="1760502" cy="1300669"/>
          </a:xfrm>
          <a:prstGeom prst="rect">
            <a:avLst/>
          </a:prstGeom>
        </p:spPr>
      </p:pic>
      <p:pic>
        <p:nvPicPr>
          <p:cNvPr id="31" name="Picture 30" descr="A grey background with many small dots&#10;&#10;AI-generated content may be incorrect.">
            <a:extLst>
              <a:ext uri="{FF2B5EF4-FFF2-40B4-BE49-F238E27FC236}">
                <a16:creationId xmlns:a16="http://schemas.microsoft.com/office/drawing/2014/main" id="{33EDF445-E729-B6C2-6CC8-01B312825A3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790997" y="7317887"/>
            <a:ext cx="1757543" cy="1299053"/>
          </a:xfrm>
          <a:prstGeom prst="rect">
            <a:avLst/>
          </a:prstGeom>
        </p:spPr>
      </p:pic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DC735262-666E-0CDC-02E3-5E530BDECE1F}"/>
              </a:ext>
            </a:extLst>
          </p:cNvPr>
          <p:cNvCxnSpPr>
            <a:cxnSpLocks/>
          </p:cNvCxnSpPr>
          <p:nvPr/>
        </p:nvCxnSpPr>
        <p:spPr>
          <a:xfrm flipV="1">
            <a:off x="5728355" y="3264668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7E15426-C71E-7472-0A75-5BD54DF08E38}"/>
              </a:ext>
            </a:extLst>
          </p:cNvPr>
          <p:cNvCxnSpPr>
            <a:cxnSpLocks/>
          </p:cNvCxnSpPr>
          <p:nvPr/>
        </p:nvCxnSpPr>
        <p:spPr>
          <a:xfrm flipV="1">
            <a:off x="7489260" y="3262920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9900C36-75AF-6F19-5F68-E8F555944B44}"/>
              </a:ext>
            </a:extLst>
          </p:cNvPr>
          <p:cNvCxnSpPr>
            <a:cxnSpLocks/>
          </p:cNvCxnSpPr>
          <p:nvPr/>
        </p:nvCxnSpPr>
        <p:spPr>
          <a:xfrm flipV="1">
            <a:off x="2130621" y="3270863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F1E149F3-B23F-3199-1735-757A4E903F18}"/>
              </a:ext>
            </a:extLst>
          </p:cNvPr>
          <p:cNvCxnSpPr>
            <a:cxnSpLocks/>
          </p:cNvCxnSpPr>
          <p:nvPr/>
        </p:nvCxnSpPr>
        <p:spPr>
          <a:xfrm flipV="1">
            <a:off x="3941385" y="3274950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61C469E0-F3BD-B151-CA01-4C881D195B3A}"/>
              </a:ext>
            </a:extLst>
          </p:cNvPr>
          <p:cNvCxnSpPr>
            <a:cxnSpLocks/>
          </p:cNvCxnSpPr>
          <p:nvPr/>
        </p:nvCxnSpPr>
        <p:spPr>
          <a:xfrm flipV="1">
            <a:off x="5728355" y="4568748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CC57A0B-D8FC-8A6C-8895-66F8ED45DF76}"/>
              </a:ext>
            </a:extLst>
          </p:cNvPr>
          <p:cNvCxnSpPr>
            <a:cxnSpLocks/>
          </p:cNvCxnSpPr>
          <p:nvPr/>
        </p:nvCxnSpPr>
        <p:spPr>
          <a:xfrm flipV="1">
            <a:off x="7489260" y="4567000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E82A2289-0BA5-0D64-543A-A09A6B2E5D8C}"/>
              </a:ext>
            </a:extLst>
          </p:cNvPr>
          <p:cNvCxnSpPr>
            <a:cxnSpLocks/>
          </p:cNvCxnSpPr>
          <p:nvPr/>
        </p:nvCxnSpPr>
        <p:spPr>
          <a:xfrm flipV="1">
            <a:off x="2130621" y="4574943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464F2B2-433A-9EA9-E606-F32FFFE80017}"/>
              </a:ext>
            </a:extLst>
          </p:cNvPr>
          <p:cNvCxnSpPr>
            <a:cxnSpLocks/>
          </p:cNvCxnSpPr>
          <p:nvPr/>
        </p:nvCxnSpPr>
        <p:spPr>
          <a:xfrm flipV="1">
            <a:off x="3941385" y="4579030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14BFB614-7D74-910C-1862-A0A779FECB80}"/>
              </a:ext>
            </a:extLst>
          </p:cNvPr>
          <p:cNvCxnSpPr>
            <a:cxnSpLocks/>
          </p:cNvCxnSpPr>
          <p:nvPr/>
        </p:nvCxnSpPr>
        <p:spPr>
          <a:xfrm flipV="1">
            <a:off x="5728355" y="7219986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7890EEFD-9321-E39F-DACC-240EE62411E8}"/>
              </a:ext>
            </a:extLst>
          </p:cNvPr>
          <p:cNvCxnSpPr>
            <a:cxnSpLocks/>
          </p:cNvCxnSpPr>
          <p:nvPr/>
        </p:nvCxnSpPr>
        <p:spPr>
          <a:xfrm flipV="1">
            <a:off x="7489260" y="7218238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E588755E-92D8-527F-BB26-D3C18A5D9350}"/>
              </a:ext>
            </a:extLst>
          </p:cNvPr>
          <p:cNvCxnSpPr>
            <a:cxnSpLocks/>
          </p:cNvCxnSpPr>
          <p:nvPr/>
        </p:nvCxnSpPr>
        <p:spPr>
          <a:xfrm flipV="1">
            <a:off x="2130621" y="7226181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3FF72AE4-1733-DF71-27B5-6840D7D6444C}"/>
              </a:ext>
            </a:extLst>
          </p:cNvPr>
          <p:cNvCxnSpPr>
            <a:cxnSpLocks/>
          </p:cNvCxnSpPr>
          <p:nvPr/>
        </p:nvCxnSpPr>
        <p:spPr>
          <a:xfrm flipV="1">
            <a:off x="3941385" y="7230268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D1A85C9-A5CE-01D1-B181-A4274949E83F}"/>
              </a:ext>
            </a:extLst>
          </p:cNvPr>
          <p:cNvCxnSpPr>
            <a:cxnSpLocks/>
          </p:cNvCxnSpPr>
          <p:nvPr/>
        </p:nvCxnSpPr>
        <p:spPr>
          <a:xfrm flipV="1">
            <a:off x="5728355" y="5884314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D8D98806-8884-D5F5-67A4-0C6ACCB6977B}"/>
              </a:ext>
            </a:extLst>
          </p:cNvPr>
          <p:cNvCxnSpPr>
            <a:cxnSpLocks/>
          </p:cNvCxnSpPr>
          <p:nvPr/>
        </p:nvCxnSpPr>
        <p:spPr>
          <a:xfrm flipV="1">
            <a:off x="7489260" y="5882566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885AF061-DCA2-0BF2-D419-38C92D09EA4A}"/>
              </a:ext>
            </a:extLst>
          </p:cNvPr>
          <p:cNvCxnSpPr>
            <a:cxnSpLocks/>
          </p:cNvCxnSpPr>
          <p:nvPr/>
        </p:nvCxnSpPr>
        <p:spPr>
          <a:xfrm flipV="1">
            <a:off x="2130621" y="5890509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0259D463-33D9-AADC-4430-C6F1E47C55BC}"/>
              </a:ext>
            </a:extLst>
          </p:cNvPr>
          <p:cNvCxnSpPr>
            <a:cxnSpLocks/>
          </p:cNvCxnSpPr>
          <p:nvPr/>
        </p:nvCxnSpPr>
        <p:spPr>
          <a:xfrm flipV="1">
            <a:off x="3941385" y="5894596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283832B-E355-83C2-9A31-7B6D51CD0B7D}"/>
              </a:ext>
            </a:extLst>
          </p:cNvPr>
          <p:cNvCxnSpPr>
            <a:cxnSpLocks/>
          </p:cNvCxnSpPr>
          <p:nvPr/>
        </p:nvCxnSpPr>
        <p:spPr>
          <a:xfrm flipV="1">
            <a:off x="5728355" y="8546289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1105D4E9-6AC4-43F2-522F-92A27F39684F}"/>
              </a:ext>
            </a:extLst>
          </p:cNvPr>
          <p:cNvCxnSpPr>
            <a:cxnSpLocks/>
          </p:cNvCxnSpPr>
          <p:nvPr/>
        </p:nvCxnSpPr>
        <p:spPr>
          <a:xfrm flipV="1">
            <a:off x="7489260" y="8544541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0162840-3F55-C0A4-801B-D50CE690FF96}"/>
              </a:ext>
            </a:extLst>
          </p:cNvPr>
          <p:cNvCxnSpPr>
            <a:cxnSpLocks/>
          </p:cNvCxnSpPr>
          <p:nvPr/>
        </p:nvCxnSpPr>
        <p:spPr>
          <a:xfrm flipV="1">
            <a:off x="2130621" y="8552484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32D8B20-34FC-26A8-3220-CFDF2335C06F}"/>
              </a:ext>
            </a:extLst>
          </p:cNvPr>
          <p:cNvCxnSpPr>
            <a:cxnSpLocks/>
          </p:cNvCxnSpPr>
          <p:nvPr/>
        </p:nvCxnSpPr>
        <p:spPr>
          <a:xfrm flipV="1">
            <a:off x="3941385" y="8556571"/>
            <a:ext cx="552591" cy="2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4D546C9C-D848-2369-080F-0FCAEA9050C9}"/>
              </a:ext>
            </a:extLst>
          </p:cNvPr>
          <p:cNvSpPr txBox="1"/>
          <p:nvPr/>
        </p:nvSpPr>
        <p:spPr>
          <a:xfrm>
            <a:off x="623455" y="9748721"/>
            <a:ext cx="758996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b="1" dirty="0"/>
              <a:t>Supplementary Figure 14.</a:t>
            </a:r>
            <a:r>
              <a:rPr lang="en-CA" sz="1000" dirty="0"/>
              <a:t> </a:t>
            </a:r>
            <a:r>
              <a:rPr lang="en-CA" sz="1000" b="1" dirty="0"/>
              <a:t>Individual channel images corresponding to the scored overlay images shown in Figure 5</a:t>
            </a:r>
            <a:r>
              <a:rPr lang="en-CA" sz="1000" dirty="0"/>
              <a:t>. </a:t>
            </a:r>
            <a:r>
              <a:rPr lang="fr-CA" sz="1000" dirty="0" err="1"/>
              <a:t>Representative</a:t>
            </a:r>
            <a:r>
              <a:rPr lang="fr-CA" sz="1000" dirty="0"/>
              <a:t> images  are </a:t>
            </a:r>
            <a:r>
              <a:rPr lang="fr-CA" sz="1000" dirty="0" err="1"/>
              <a:t>presented</a:t>
            </a:r>
            <a:r>
              <a:rPr lang="fr-CA" sz="1000" dirty="0"/>
              <a:t> for </a:t>
            </a:r>
            <a:r>
              <a:rPr lang="fr-CA" sz="1000" dirty="0" err="1"/>
              <a:t>each</a:t>
            </a:r>
            <a:r>
              <a:rPr lang="fr-CA" sz="1000" dirty="0"/>
              <a:t> </a:t>
            </a:r>
            <a:r>
              <a:rPr lang="fr-CA" sz="1000" dirty="0" err="1"/>
              <a:t>channel</a:t>
            </a:r>
            <a:r>
              <a:rPr lang="fr-CA" sz="1000" dirty="0"/>
              <a:t>: 1) phase-</a:t>
            </a:r>
            <a:r>
              <a:rPr lang="fr-CA" sz="1000" dirty="0" err="1"/>
              <a:t>contrast</a:t>
            </a:r>
            <a:r>
              <a:rPr lang="fr-CA" sz="1000" dirty="0"/>
              <a:t>, 2) DNA (green), 3) </a:t>
            </a:r>
            <a:r>
              <a:rPr lang="fr-CA" sz="1000" dirty="0" err="1"/>
              <a:t>Annexin</a:t>
            </a:r>
            <a:r>
              <a:rPr lang="fr-CA" sz="1000" dirty="0"/>
              <a:t> V (</a:t>
            </a:r>
            <a:r>
              <a:rPr lang="fr-CA" sz="1000" dirty="0" err="1"/>
              <a:t>red</a:t>
            </a:r>
            <a:r>
              <a:rPr lang="fr-CA" sz="1000" dirty="0"/>
              <a:t>), 4) the composite overlay, and 5) </a:t>
            </a:r>
            <a:r>
              <a:rPr lang="fr-CA" sz="1000" dirty="0" err="1"/>
              <a:t>scored</a:t>
            </a:r>
            <a:r>
              <a:rPr lang="fr-CA" sz="1000" dirty="0"/>
              <a:t> images. </a:t>
            </a:r>
            <a:r>
              <a:rPr lang="fr-CA" sz="1000" dirty="0" err="1"/>
              <a:t>Scale</a:t>
            </a:r>
            <a:r>
              <a:rPr lang="fr-CA" sz="1000" dirty="0"/>
              <a:t> bar = 30 µm. </a:t>
            </a:r>
            <a:endParaRPr lang="en-US" sz="1000" dirty="0"/>
          </a:p>
        </p:txBody>
      </p:sp>
      <p:graphicFrame>
        <p:nvGraphicFramePr>
          <p:cNvPr id="58" name="Table 57">
            <a:extLst>
              <a:ext uri="{FF2B5EF4-FFF2-40B4-BE49-F238E27FC236}">
                <a16:creationId xmlns:a16="http://schemas.microsoft.com/office/drawing/2014/main" id="{BE8FC7B9-0C96-BDCB-79D1-E9DC185821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4987971"/>
              </p:ext>
            </p:extLst>
          </p:nvPr>
        </p:nvGraphicFramePr>
        <p:xfrm>
          <a:off x="1016234" y="1616945"/>
          <a:ext cx="7102640" cy="3854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75660">
                  <a:extLst>
                    <a:ext uri="{9D8B030D-6E8A-4147-A177-3AD203B41FA5}">
                      <a16:colId xmlns:a16="http://schemas.microsoft.com/office/drawing/2014/main" val="882506453"/>
                    </a:ext>
                  </a:extLst>
                </a:gridCol>
                <a:gridCol w="1775660">
                  <a:extLst>
                    <a:ext uri="{9D8B030D-6E8A-4147-A177-3AD203B41FA5}">
                      <a16:colId xmlns:a16="http://schemas.microsoft.com/office/drawing/2014/main" val="1442165256"/>
                    </a:ext>
                  </a:extLst>
                </a:gridCol>
                <a:gridCol w="1775660">
                  <a:extLst>
                    <a:ext uri="{9D8B030D-6E8A-4147-A177-3AD203B41FA5}">
                      <a16:colId xmlns:a16="http://schemas.microsoft.com/office/drawing/2014/main" val="3393140818"/>
                    </a:ext>
                  </a:extLst>
                </a:gridCol>
                <a:gridCol w="1775660">
                  <a:extLst>
                    <a:ext uri="{9D8B030D-6E8A-4147-A177-3AD203B41FA5}">
                      <a16:colId xmlns:a16="http://schemas.microsoft.com/office/drawing/2014/main" val="3201431331"/>
                    </a:ext>
                  </a:extLst>
                </a:gridCol>
              </a:tblGrid>
              <a:tr h="385433"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ysClr val="windowText" lastClr="000000"/>
                          </a:solidFill>
                        </a:rPr>
                        <a:t>W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ysClr val="windowText" lastClr="000000"/>
                          </a:solidFill>
                        </a:rPr>
                        <a:t>WT + PM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ysClr val="windowText" lastClr="000000"/>
                          </a:solidFill>
                        </a:rPr>
                        <a:t>Padi4</a:t>
                      </a:r>
                      <a:r>
                        <a:rPr lang="en-US" sz="1600" b="0" baseline="30000">
                          <a:solidFill>
                            <a:sysClr val="windowText" lastClr="000000"/>
                          </a:solidFill>
                        </a:rPr>
                        <a:t>-/-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899952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>
                          <a:solidFill>
                            <a:sysClr val="windowText" lastClr="000000"/>
                          </a:solidFill>
                        </a:rPr>
                        <a:t>Padi4</a:t>
                      </a:r>
                      <a:r>
                        <a:rPr lang="en-US" sz="1600" b="0" baseline="30000">
                          <a:solidFill>
                            <a:sysClr val="windowText" lastClr="000000"/>
                          </a:solidFill>
                        </a:rPr>
                        <a:t>-/-  </a:t>
                      </a:r>
                      <a:r>
                        <a:rPr lang="en-US" sz="1600" b="0" baseline="0">
                          <a:solidFill>
                            <a:sysClr val="windowText" lastClr="000000"/>
                          </a:solidFill>
                        </a:rPr>
                        <a:t>+ PMA</a:t>
                      </a:r>
                      <a:endParaRPr lang="en-US" sz="1600" b="0" baseline="3000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4781195"/>
                  </a:ext>
                </a:extLst>
              </a:tr>
            </a:tbl>
          </a:graphicData>
        </a:graphic>
      </p:graphicFrame>
      <p:graphicFrame>
        <p:nvGraphicFramePr>
          <p:cNvPr id="59" name="Table 58">
            <a:extLst>
              <a:ext uri="{FF2B5EF4-FFF2-40B4-BE49-F238E27FC236}">
                <a16:creationId xmlns:a16="http://schemas.microsoft.com/office/drawing/2014/main" id="{D2EBEFDE-CCBF-A6A0-33AF-D4ECAD5495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5913907"/>
              </p:ext>
            </p:extLst>
          </p:nvPr>
        </p:nvGraphicFramePr>
        <p:xfrm>
          <a:off x="623455" y="2063340"/>
          <a:ext cx="367863" cy="6553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7863">
                  <a:extLst>
                    <a:ext uri="{9D8B030D-6E8A-4147-A177-3AD203B41FA5}">
                      <a16:colId xmlns:a16="http://schemas.microsoft.com/office/drawing/2014/main" val="1429448387"/>
                    </a:ext>
                  </a:extLst>
                </a:gridCol>
              </a:tblGrid>
              <a:tr h="1310720"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chemeClr val="tx1"/>
                          </a:solidFill>
                        </a:rPr>
                        <a:t>Phase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344441"/>
                  </a:ext>
                </a:extLst>
              </a:tr>
              <a:tr h="1310720"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chemeClr val="tx1"/>
                          </a:solidFill>
                        </a:rPr>
                        <a:t>DNA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373286"/>
                  </a:ext>
                </a:extLst>
              </a:tr>
              <a:tr h="1310720"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chemeClr val="tx1"/>
                          </a:solidFill>
                        </a:rPr>
                        <a:t>Annexin V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18830"/>
                  </a:ext>
                </a:extLst>
              </a:tr>
              <a:tr h="1310720"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chemeClr val="tx1"/>
                          </a:solidFill>
                        </a:rPr>
                        <a:t>Overlay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6516312"/>
                  </a:ext>
                </a:extLst>
              </a:tr>
              <a:tr h="1310720">
                <a:tc>
                  <a:txBody>
                    <a:bodyPr/>
                    <a:lstStyle/>
                    <a:p>
                      <a:pPr algn="ctr"/>
                      <a:r>
                        <a:rPr lang="en-US" sz="1600" b="0">
                          <a:solidFill>
                            <a:schemeClr val="tx1"/>
                          </a:solidFill>
                        </a:rPr>
                        <a:t>Scored image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484963"/>
                  </a:ext>
                </a:extLst>
              </a:tr>
            </a:tbl>
          </a:graphicData>
        </a:graphic>
      </p:graphicFrame>
      <p:grpSp>
        <p:nvGrpSpPr>
          <p:cNvPr id="15" name="Group 14">
            <a:extLst>
              <a:ext uri="{FF2B5EF4-FFF2-40B4-BE49-F238E27FC236}">
                <a16:creationId xmlns:a16="http://schemas.microsoft.com/office/drawing/2014/main" id="{2CB73F0E-7CAA-637C-7F50-7E0ECE9C20EE}"/>
              </a:ext>
            </a:extLst>
          </p:cNvPr>
          <p:cNvGrpSpPr/>
          <p:nvPr/>
        </p:nvGrpSpPr>
        <p:grpSpPr>
          <a:xfrm>
            <a:off x="6795041" y="8789267"/>
            <a:ext cx="1323833" cy="787127"/>
            <a:chOff x="6795041" y="8789267"/>
            <a:chExt cx="1323833" cy="787127"/>
          </a:xfrm>
        </p:grpSpPr>
        <p:pic>
          <p:nvPicPr>
            <p:cNvPr id="33" name="Picture 32" descr="A list of numbers on a screen&#10;&#10;AI-generated content may be incorrect.">
              <a:extLst>
                <a:ext uri="{FF2B5EF4-FFF2-40B4-BE49-F238E27FC236}">
                  <a16:creationId xmlns:a16="http://schemas.microsoft.com/office/drawing/2014/main" id="{EF29CD18-352B-1758-5456-A6B7DDCEC8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/>
            <a:srcRect l="10537" t="15098" r="11672"/>
            <a:stretch>
              <a:fillRect/>
            </a:stretch>
          </p:blipFill>
          <p:spPr>
            <a:xfrm>
              <a:off x="6795041" y="8789267"/>
              <a:ext cx="1323833" cy="787127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0853324C-D8A7-16E3-E01D-AEB9A2E1C343}"/>
                </a:ext>
              </a:extLst>
            </p:cNvPr>
            <p:cNvSpPr/>
            <p:nvPr/>
          </p:nvSpPr>
          <p:spPr>
            <a:xfrm>
              <a:off x="7411212" y="8833104"/>
              <a:ext cx="137160" cy="118872"/>
            </a:xfrm>
            <a:prstGeom prst="rect">
              <a:avLst/>
            </a:prstGeom>
            <a:solidFill>
              <a:srgbClr val="6724FE"/>
            </a:solidFill>
            <a:ln>
              <a:solidFill>
                <a:srgbClr val="6724FE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3D1FF2C1-36F5-EF3C-B508-BEE28BC394CE}"/>
                </a:ext>
              </a:extLst>
            </p:cNvPr>
            <p:cNvSpPr/>
            <p:nvPr/>
          </p:nvSpPr>
          <p:spPr>
            <a:xfrm>
              <a:off x="7352100" y="9124302"/>
              <a:ext cx="137160" cy="108819"/>
            </a:xfrm>
            <a:prstGeom prst="rect">
              <a:avLst/>
            </a:prstGeom>
            <a:solidFill>
              <a:srgbClr val="00B4EC"/>
            </a:solidFill>
            <a:ln>
              <a:solidFill>
                <a:srgbClr val="00B4EC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323BFE9-58B7-3726-1C6F-693961093F65}"/>
                </a:ext>
              </a:extLst>
            </p:cNvPr>
            <p:cNvSpPr/>
            <p:nvPr/>
          </p:nvSpPr>
          <p:spPr>
            <a:xfrm>
              <a:off x="7283519" y="9264875"/>
              <a:ext cx="174555" cy="108819"/>
            </a:xfrm>
            <a:prstGeom prst="rect">
              <a:avLst/>
            </a:prstGeom>
            <a:solidFill>
              <a:srgbClr val="32E3D9"/>
            </a:solidFill>
            <a:ln>
              <a:solidFill>
                <a:srgbClr val="32E3D9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C8869038-9E5B-0EFB-7E3C-1943642A24F2}"/>
                </a:ext>
              </a:extLst>
            </p:cNvPr>
            <p:cNvSpPr/>
            <p:nvPr/>
          </p:nvSpPr>
          <p:spPr>
            <a:xfrm>
              <a:off x="7474782" y="9405447"/>
              <a:ext cx="174555" cy="108819"/>
            </a:xfrm>
            <a:prstGeom prst="rect">
              <a:avLst/>
            </a:prstGeom>
            <a:solidFill>
              <a:srgbClr val="65FCC1"/>
            </a:solidFill>
            <a:ln>
              <a:solidFill>
                <a:srgbClr val="65FCC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4A46B69-B761-3756-AAE5-AE94E5B03A12}"/>
                </a:ext>
              </a:extLst>
            </p:cNvPr>
            <p:cNvSpPr/>
            <p:nvPr/>
          </p:nvSpPr>
          <p:spPr>
            <a:xfrm>
              <a:off x="7652535" y="8982297"/>
              <a:ext cx="45719" cy="108819"/>
            </a:xfrm>
            <a:prstGeom prst="rect">
              <a:avLst/>
            </a:prstGeom>
            <a:solidFill>
              <a:srgbClr val="3373F9"/>
            </a:solidFill>
            <a:ln>
              <a:solidFill>
                <a:srgbClr val="3373F9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987809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3">
            <a:extLst>
              <a:ext uri="{FF2B5EF4-FFF2-40B4-BE49-F238E27FC236}">
                <a16:creationId xmlns:a16="http://schemas.microsoft.com/office/drawing/2014/main" id="{080B8E15-A451-2357-0A15-737E8EEAE7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77584" t="44974" b="35147"/>
          <a:stretch>
            <a:fillRect/>
          </a:stretch>
        </p:blipFill>
        <p:spPr>
          <a:xfrm>
            <a:off x="7019345" y="4589022"/>
            <a:ext cx="1064187" cy="658260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D8EA881F-7357-103A-16C8-73339AB240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r="21560"/>
          <a:stretch>
            <a:fillRect/>
          </a:stretch>
        </p:blipFill>
        <p:spPr>
          <a:xfrm>
            <a:off x="804575" y="4577675"/>
            <a:ext cx="3081776" cy="2740274"/>
          </a:xfrm>
          <a:prstGeom prst="rect">
            <a:avLst/>
          </a:prstGeom>
        </p:spPr>
      </p:pic>
      <p:pic>
        <p:nvPicPr>
          <p:cNvPr id="6" name="Graphic 5">
            <a:extLst>
              <a:ext uri="{FF2B5EF4-FFF2-40B4-BE49-F238E27FC236}">
                <a16:creationId xmlns:a16="http://schemas.microsoft.com/office/drawing/2014/main" id="{9BCAEA85-DEAA-C808-3188-87BFB76B6E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r="24081"/>
          <a:stretch>
            <a:fillRect/>
          </a:stretch>
        </p:blipFill>
        <p:spPr>
          <a:xfrm>
            <a:off x="4058942" y="4589022"/>
            <a:ext cx="2940217" cy="27012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0A531A1-FB91-EB7E-C32D-C2AEF8866636}"/>
              </a:ext>
            </a:extLst>
          </p:cNvPr>
          <p:cNvSpPr txBox="1"/>
          <p:nvPr/>
        </p:nvSpPr>
        <p:spPr>
          <a:xfrm>
            <a:off x="790641" y="7416340"/>
            <a:ext cx="740432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</a:t>
            </a:r>
            <a:r>
              <a:rPr lang="fr-CA" sz="1000" b="1" dirty="0"/>
              <a:t>15. </a:t>
            </a:r>
            <a:r>
              <a:rPr lang="en-CA" sz="1000" b="1" dirty="0"/>
              <a:t>Line plots of the percentage of negative and dead cells over time in bone marrow-derived neutrophil experiments. </a:t>
            </a:r>
            <a:r>
              <a:rPr lang="en-CA" sz="1000" dirty="0"/>
              <a:t>Median proportions with 95% confidence interval are shown for WT and </a:t>
            </a:r>
            <a:r>
              <a:rPr lang="en-CA" sz="1000" i="1" dirty="0"/>
              <a:t>Padi4</a:t>
            </a:r>
            <a:r>
              <a:rPr lang="en-CA" sz="1000" baseline="30000" dirty="0"/>
              <a:t>-/- </a:t>
            </a:r>
            <a:r>
              <a:rPr lang="en-CA" sz="1000" dirty="0"/>
              <a:t>neutrophils with or without PMA stimulation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893400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showing the number of the cell state&#10;&#10;AI-generated content may be incorrect.">
            <a:extLst>
              <a:ext uri="{FF2B5EF4-FFF2-40B4-BE49-F238E27FC236}">
                <a16:creationId xmlns:a16="http://schemas.microsoft.com/office/drawing/2014/main" id="{5D129D44-A979-14CB-AE96-A521B78E495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31294"/>
          <a:stretch>
            <a:fillRect/>
          </a:stretch>
        </p:blipFill>
        <p:spPr>
          <a:xfrm>
            <a:off x="4135941" y="4271728"/>
            <a:ext cx="3086743" cy="2200510"/>
          </a:xfrm>
          <a:prstGeom prst="rect">
            <a:avLst/>
          </a:prstGeom>
        </p:spPr>
      </p:pic>
      <p:pic>
        <p:nvPicPr>
          <p:cNvPr id="5" name="Picture 4" descr="A graph showing the number of the cell-state composition&#10;&#10;AI-generated content may be incorrect.">
            <a:extLst>
              <a:ext uri="{FF2B5EF4-FFF2-40B4-BE49-F238E27FC236}">
                <a16:creationId xmlns:a16="http://schemas.microsoft.com/office/drawing/2014/main" id="{70EA11C6-7D34-6FD1-2623-8C357BCB6FF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" r="30723"/>
          <a:stretch>
            <a:fillRect/>
          </a:stretch>
        </p:blipFill>
        <p:spPr>
          <a:xfrm>
            <a:off x="4135941" y="1723576"/>
            <a:ext cx="3112374" cy="2200510"/>
          </a:xfrm>
          <a:prstGeom prst="rect">
            <a:avLst/>
          </a:prstGeom>
        </p:spPr>
      </p:pic>
      <p:pic>
        <p:nvPicPr>
          <p:cNvPr id="6" name="Picture 5" descr="A graph showing a number and a graph&#10;&#10;AI-generated content may be incorrect.">
            <a:extLst>
              <a:ext uri="{FF2B5EF4-FFF2-40B4-BE49-F238E27FC236}">
                <a16:creationId xmlns:a16="http://schemas.microsoft.com/office/drawing/2014/main" id="{2DB5D770-F1D7-E78B-ED8D-1F93F7034E9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29947"/>
          <a:stretch>
            <a:fillRect/>
          </a:stretch>
        </p:blipFill>
        <p:spPr>
          <a:xfrm>
            <a:off x="912163" y="4295865"/>
            <a:ext cx="3147294" cy="2200510"/>
          </a:xfrm>
          <a:prstGeom prst="rect">
            <a:avLst/>
          </a:prstGeom>
        </p:spPr>
      </p:pic>
      <p:pic>
        <p:nvPicPr>
          <p:cNvPr id="7" name="Picture 6" descr="A graph of a cell phone number&#10;&#10;AI-generated content may be incorrect.">
            <a:extLst>
              <a:ext uri="{FF2B5EF4-FFF2-40B4-BE49-F238E27FC236}">
                <a16:creationId xmlns:a16="http://schemas.microsoft.com/office/drawing/2014/main" id="{D3037F51-6E62-2D03-582B-F25BCCF7B515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31176"/>
          <a:stretch>
            <a:fillRect/>
          </a:stretch>
        </p:blipFill>
        <p:spPr>
          <a:xfrm>
            <a:off x="901880" y="1755129"/>
            <a:ext cx="3092043" cy="2200510"/>
          </a:xfrm>
          <a:prstGeom prst="rect">
            <a:avLst/>
          </a:prstGeom>
        </p:spPr>
      </p:pic>
      <p:pic>
        <p:nvPicPr>
          <p:cNvPr id="8" name="Picture 7" descr="A graph of a cell phone number&#10;&#10;AI-generated content may be incorrect.">
            <a:extLst>
              <a:ext uri="{FF2B5EF4-FFF2-40B4-BE49-F238E27FC236}">
                <a16:creationId xmlns:a16="http://schemas.microsoft.com/office/drawing/2014/main" id="{1EE7D4AD-25A3-6290-C634-25B1CDABA62B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69173" t="35036" b="39788"/>
          <a:stretch>
            <a:fillRect/>
          </a:stretch>
        </p:blipFill>
        <p:spPr>
          <a:xfrm>
            <a:off x="6848451" y="1949686"/>
            <a:ext cx="1384962" cy="55399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CEE59E0-F0E8-95AD-DC8B-4AEAED4C66B9}"/>
              </a:ext>
            </a:extLst>
          </p:cNvPr>
          <p:cNvSpPr txBox="1"/>
          <p:nvPr/>
        </p:nvSpPr>
        <p:spPr>
          <a:xfrm>
            <a:off x="914819" y="6777579"/>
            <a:ext cx="67372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</a:t>
            </a:r>
            <a:r>
              <a:rPr lang="fr-CA" sz="1000" b="1" dirty="0"/>
              <a:t>16. </a:t>
            </a:r>
            <a:r>
              <a:rPr lang="fr-CA" sz="1000" b="1" dirty="0" err="1"/>
              <a:t>Compositional</a:t>
            </a:r>
            <a:r>
              <a:rPr lang="fr-CA" sz="1000" b="1" dirty="0"/>
              <a:t> </a:t>
            </a:r>
            <a:r>
              <a:rPr lang="fr-CA" sz="1000" b="1" dirty="0" err="1"/>
              <a:t>stacked</a:t>
            </a:r>
            <a:r>
              <a:rPr lang="fr-CA" sz="1000" b="1" dirty="0"/>
              <a:t> area plots for mouse </a:t>
            </a:r>
            <a:r>
              <a:rPr lang="fr-CA" sz="1000" b="1" dirty="0" err="1"/>
              <a:t>bone</a:t>
            </a:r>
            <a:r>
              <a:rPr lang="fr-CA" sz="1000" b="1" dirty="0"/>
              <a:t> </a:t>
            </a:r>
            <a:r>
              <a:rPr lang="fr-CA" sz="1000" b="1" dirty="0" err="1"/>
              <a:t>marrow-derived</a:t>
            </a:r>
            <a:r>
              <a:rPr lang="fr-CA" sz="1000" b="1" dirty="0"/>
              <a:t> </a:t>
            </a:r>
            <a:r>
              <a:rPr lang="fr-CA" sz="1000" b="1" dirty="0" err="1"/>
              <a:t>neutrophil</a:t>
            </a:r>
            <a:r>
              <a:rPr lang="fr-CA" sz="1000" b="1" dirty="0"/>
              <a:t> </a:t>
            </a:r>
            <a:r>
              <a:rPr lang="fr-CA" sz="1000" b="1" dirty="0" err="1"/>
              <a:t>treatment</a:t>
            </a:r>
            <a:r>
              <a:rPr lang="fr-CA" sz="1000" b="1" dirty="0"/>
              <a:t> groups. </a:t>
            </a:r>
            <a:r>
              <a:rPr lang="en-CA" sz="1000" dirty="0"/>
              <a:t>n = 4 experiments, N = 12-15 replicates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877368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0</TotalTime>
  <Words>364</Words>
  <Application>Microsoft Macintosh PowerPoint</Application>
  <PresentationFormat>Custom</PresentationFormat>
  <Paragraphs>58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loé Landry</dc:creator>
  <cp:lastModifiedBy>Chloé Landry</cp:lastModifiedBy>
  <cp:revision>2</cp:revision>
  <dcterms:created xsi:type="dcterms:W3CDTF">2025-08-09T22:46:12Z</dcterms:created>
  <dcterms:modified xsi:type="dcterms:W3CDTF">2026-02-07T00:28:47Z</dcterms:modified>
</cp:coreProperties>
</file>